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sldIdLst>
    <p:sldId id="256" r:id="rId2"/>
    <p:sldId id="264" r:id="rId3"/>
    <p:sldId id="259" r:id="rId4"/>
    <p:sldId id="262" r:id="rId5"/>
    <p:sldId id="258" r:id="rId6"/>
    <p:sldId id="265" r:id="rId7"/>
    <p:sldId id="260" r:id="rId8"/>
    <p:sldId id="261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F8F"/>
    <a:srgbClr val="00218E"/>
    <a:srgbClr val="00F622"/>
    <a:srgbClr val="001A5F"/>
    <a:srgbClr val="001367"/>
    <a:srgbClr val="000000"/>
    <a:srgbClr val="00FE00"/>
    <a:srgbClr val="001B8C"/>
    <a:srgbClr val="006A29"/>
    <a:srgbClr val="00050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58" autoAdjust="0"/>
    <p:restoredTop sz="96349" autoAdjust="0"/>
  </p:normalViewPr>
  <p:slideViewPr>
    <p:cSldViewPr snapToGrid="0" showGuides="1">
      <p:cViewPr>
        <p:scale>
          <a:sx n="73" d="100"/>
          <a:sy n="73" d="100"/>
        </p:scale>
        <p:origin x="264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5AE84C-990C-45FE-8ABA-9772B1988D7E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05D6A5-0ED9-42AF-87B0-143F17E55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59764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192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9030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3959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8360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999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7061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1127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3205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9660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6596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5648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10AECF-7DB5-4533-AFDE-39B5828A6066}" type="datetimeFigureOut">
              <a:rPr lang="zh-CN" altLang="en-US" smtClean="0"/>
              <a:t>2025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20718-530E-4F96-8959-B84D3839F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461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5" Type="http://schemas.openxmlformats.org/officeDocument/2006/relationships/image" Target="../media/image46.png"/><Relationship Id="rId10" Type="http://schemas.openxmlformats.org/officeDocument/2006/relationships/image" Target="../media/image51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图片 65">
            <a:extLst>
              <a:ext uri="{FF2B5EF4-FFF2-40B4-BE49-F238E27FC236}">
                <a16:creationId xmlns:a16="http://schemas.microsoft.com/office/drawing/2014/main" id="{6F24A7BE-A564-2727-BA40-FE314F5C5F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8810" y="6116217"/>
            <a:ext cx="1514686" cy="2257740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09B21C3E-CCA8-C6C8-C95B-6813F31BF7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8810" y="2951904"/>
            <a:ext cx="1362265" cy="2248214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E917557C-42C7-BBE3-29CC-40C1D8E8F7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8725" y="2951904"/>
            <a:ext cx="1867161" cy="2353003"/>
          </a:xfrm>
          <a:prstGeom prst="rect">
            <a:avLst/>
          </a:prstGeom>
        </p:spPr>
      </p:pic>
      <p:pic>
        <p:nvPicPr>
          <p:cNvPr id="87" name="图片 86">
            <a:extLst>
              <a:ext uri="{FF2B5EF4-FFF2-40B4-BE49-F238E27FC236}">
                <a16:creationId xmlns:a16="http://schemas.microsoft.com/office/drawing/2014/main" id="{B1A454E2-98FC-850B-3DF5-FC52918D19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7025" y="6154322"/>
            <a:ext cx="1724266" cy="2219635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923E0B6C-5C2C-2829-3EAC-DB16F046633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5037" y="2951904"/>
            <a:ext cx="1810003" cy="2476846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CDE028AD-2BFA-B0E0-8DC1-C12A5AB54A7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25037" y="5997137"/>
            <a:ext cx="1867161" cy="2534004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CAC2E439-8A47-5EC0-41FE-839CFF9B997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23999" y="3021783"/>
            <a:ext cx="1324160" cy="2038635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3D864B14-8402-B853-709D-FD020389B08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78392" y="6297216"/>
            <a:ext cx="1371791" cy="1933845"/>
          </a:xfrm>
          <a:prstGeom prst="rect">
            <a:avLst/>
          </a:prstGeom>
        </p:spPr>
      </p:pic>
      <p:grpSp>
        <p:nvGrpSpPr>
          <p:cNvPr id="33" name="组合 32">
            <a:extLst>
              <a:ext uri="{FF2B5EF4-FFF2-40B4-BE49-F238E27FC236}">
                <a16:creationId xmlns:a16="http://schemas.microsoft.com/office/drawing/2014/main" id="{FC5F6BDA-9A83-9762-4C02-4733F5C02BC3}"/>
              </a:ext>
            </a:extLst>
          </p:cNvPr>
          <p:cNvGrpSpPr/>
          <p:nvPr/>
        </p:nvGrpSpPr>
        <p:grpSpPr>
          <a:xfrm>
            <a:off x="251662" y="669074"/>
            <a:ext cx="2509778" cy="1599301"/>
            <a:chOff x="261267" y="169857"/>
            <a:chExt cx="2509778" cy="1599301"/>
          </a:xfrm>
        </p:grpSpPr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C6259804-41FD-7E59-9247-331E8EF65700}"/>
                </a:ext>
              </a:extLst>
            </p:cNvPr>
            <p:cNvGrpSpPr/>
            <p:nvPr/>
          </p:nvGrpSpPr>
          <p:grpSpPr>
            <a:xfrm>
              <a:off x="1873312" y="360090"/>
              <a:ext cx="897733" cy="1106209"/>
              <a:chOff x="3585252" y="241766"/>
              <a:chExt cx="897733" cy="1106209"/>
            </a:xfrm>
          </p:grpSpPr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5D9434D3-2056-D223-0B7E-FBF9096032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rcRect l="20001" t="64446" r="14724" b="21886"/>
              <a:stretch/>
            </p:blipFill>
            <p:spPr>
              <a:xfrm>
                <a:off x="3585252" y="1083656"/>
                <a:ext cx="895438" cy="264319"/>
              </a:xfrm>
              <a:prstGeom prst="rect">
                <a:avLst/>
              </a:prstGeom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02F001B8-3D79-0601-03E2-1291F6E4AB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21427" t="49784" r="19457" b="38509"/>
              <a:stretch/>
            </p:blipFill>
            <p:spPr>
              <a:xfrm>
                <a:off x="3585252" y="802513"/>
                <a:ext cx="895438" cy="264319"/>
              </a:xfrm>
              <a:prstGeom prst="rect">
                <a:avLst/>
              </a:prstGeom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B9165FCA-D3DC-CB3E-14C2-18005C2E99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21368" t="38459" r="28491" b="50044"/>
              <a:stretch/>
            </p:blipFill>
            <p:spPr>
              <a:xfrm>
                <a:off x="3585252" y="523155"/>
                <a:ext cx="895438" cy="264319"/>
              </a:xfrm>
              <a:prstGeom prst="rect">
                <a:avLst/>
              </a:prstGeom>
            </p:spPr>
          </p:pic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43DB5A44-DFE7-BD00-34C0-509F326AA3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l="23331" t="20214" r="28590" b="69355"/>
              <a:stretch/>
            </p:blipFill>
            <p:spPr>
              <a:xfrm>
                <a:off x="3585252" y="241766"/>
                <a:ext cx="897733" cy="264319"/>
              </a:xfrm>
              <a:prstGeom prst="rect">
                <a:avLst/>
              </a:prstGeom>
            </p:spPr>
          </p:pic>
        </p:grpSp>
        <p:grpSp>
          <p:nvGrpSpPr>
            <p:cNvPr id="17" name="组合 16"/>
            <p:cNvGrpSpPr/>
            <p:nvPr/>
          </p:nvGrpSpPr>
          <p:grpSpPr>
            <a:xfrm>
              <a:off x="261267" y="169857"/>
              <a:ext cx="2502156" cy="1599301"/>
              <a:chOff x="97437" y="-187331"/>
              <a:chExt cx="2502156" cy="1599301"/>
            </a:xfrm>
          </p:grpSpPr>
          <p:sp>
            <p:nvSpPr>
              <p:cNvPr id="3" name="矩形 2"/>
              <p:cNvSpPr/>
              <p:nvPr/>
            </p:nvSpPr>
            <p:spPr>
              <a:xfrm>
                <a:off x="1028170" y="-184950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1963879" y="-187331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2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组合 15"/>
              <p:cNvGrpSpPr/>
              <p:nvPr/>
            </p:nvGrpSpPr>
            <p:grpSpPr>
              <a:xfrm>
                <a:off x="97437" y="27339"/>
                <a:ext cx="2502156" cy="1384631"/>
                <a:chOff x="97437" y="27339"/>
                <a:chExt cx="2502156" cy="1384631"/>
              </a:xfrm>
            </p:grpSpPr>
            <p:sp>
              <p:nvSpPr>
                <p:cNvPr id="2" name="矩形 1"/>
                <p:cNvSpPr/>
                <p:nvPr/>
              </p:nvSpPr>
              <p:spPr>
                <a:xfrm>
                  <a:off x="348018" y="27339"/>
                  <a:ext cx="476412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estin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矩形 4"/>
                <p:cNvSpPr/>
                <p:nvPr/>
              </p:nvSpPr>
              <p:spPr>
                <a:xfrm rot="18900000">
                  <a:off x="596812" y="1171852"/>
                  <a:ext cx="516488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矩形 5"/>
                <p:cNvSpPr/>
                <p:nvPr/>
              </p:nvSpPr>
              <p:spPr>
                <a:xfrm rot="18900000">
                  <a:off x="796062" y="1192820"/>
                  <a:ext cx="575799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vo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×1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矩形 6"/>
                <p:cNvSpPr/>
                <p:nvPr/>
              </p:nvSpPr>
              <p:spPr>
                <a:xfrm rot="18900000">
                  <a:off x="1069474" y="1196526"/>
                  <a:ext cx="575799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vo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×3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矩形 7"/>
                <p:cNvSpPr/>
                <p:nvPr/>
              </p:nvSpPr>
              <p:spPr>
                <a:xfrm>
                  <a:off x="97437" y="309159"/>
                  <a:ext cx="731290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l-GR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bulin III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矩形 8"/>
                <p:cNvSpPr/>
                <p:nvPr/>
              </p:nvSpPr>
              <p:spPr>
                <a:xfrm>
                  <a:off x="359239" y="598423"/>
                  <a:ext cx="465191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FAP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矩形 9"/>
                <p:cNvSpPr/>
                <p:nvPr/>
              </p:nvSpPr>
              <p:spPr>
                <a:xfrm>
                  <a:off x="274279" y="869229"/>
                  <a:ext cx="550151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矩形 11"/>
                <p:cNvSpPr/>
                <p:nvPr/>
              </p:nvSpPr>
              <p:spPr>
                <a:xfrm rot="18900000">
                  <a:off x="1536394" y="1171850"/>
                  <a:ext cx="516488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矩形 12"/>
                <p:cNvSpPr/>
                <p:nvPr/>
              </p:nvSpPr>
              <p:spPr>
                <a:xfrm rot="18900000">
                  <a:off x="1761520" y="1192821"/>
                  <a:ext cx="575799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vo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×1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矩形 13"/>
                <p:cNvSpPr/>
                <p:nvPr/>
              </p:nvSpPr>
              <p:spPr>
                <a:xfrm rot="18900000">
                  <a:off x="2023794" y="1192821"/>
                  <a:ext cx="575799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vo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×3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B1984D88-6904-A8C0-E0BC-7CD95A310D9E}"/>
                </a:ext>
              </a:extLst>
            </p:cNvPr>
            <p:cNvGrpSpPr/>
            <p:nvPr/>
          </p:nvGrpSpPr>
          <p:grpSpPr>
            <a:xfrm>
              <a:off x="936456" y="360090"/>
              <a:ext cx="897733" cy="1107743"/>
              <a:chOff x="3717139" y="50987"/>
              <a:chExt cx="897733" cy="1107743"/>
            </a:xfrm>
          </p:grpSpPr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13BE295B-F93C-707B-1084-03BBB42C06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rcRect l="17085" t="62318" r="12775" b="24268"/>
              <a:stretch/>
            </p:blipFill>
            <p:spPr>
              <a:xfrm>
                <a:off x="3717139" y="894410"/>
                <a:ext cx="897732" cy="264320"/>
              </a:xfrm>
              <a:prstGeom prst="rect">
                <a:avLst/>
              </a:prstGeom>
            </p:spPr>
          </p:pic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7B82DAA2-8991-338B-0AC8-5D4F9EAF66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19291" t="48994" r="16263" b="39249"/>
              <a:stretch/>
            </p:blipFill>
            <p:spPr>
              <a:xfrm>
                <a:off x="3717139" y="617846"/>
                <a:ext cx="897733" cy="264320"/>
              </a:xfrm>
              <a:prstGeom prst="rect">
                <a:avLst/>
              </a:prstGeom>
            </p:spPr>
          </p:pic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176A7F3F-8AB6-20DC-B89F-E5CBE7161D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28254" t="46767" r="26092" b="41890"/>
              <a:stretch/>
            </p:blipFill>
            <p:spPr>
              <a:xfrm>
                <a:off x="3717139" y="327571"/>
                <a:ext cx="897732" cy="276999"/>
              </a:xfrm>
              <a:prstGeom prst="rect">
                <a:avLst/>
              </a:prstGeom>
            </p:spPr>
          </p:pic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EB2DF9BA-27C5-684A-3344-0269842F6A5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l="22904" t="22224" r="27497" b="67104"/>
              <a:stretch/>
            </p:blipFill>
            <p:spPr>
              <a:xfrm>
                <a:off x="3717139" y="50987"/>
                <a:ext cx="897732" cy="264319"/>
              </a:xfrm>
              <a:prstGeom prst="rect">
                <a:avLst/>
              </a:prstGeom>
            </p:spPr>
          </p:pic>
        </p:grpSp>
      </p:grpSp>
      <p:sp>
        <p:nvSpPr>
          <p:cNvPr id="19" name="矩形 18">
            <a:extLst>
              <a:ext uri="{FF2B5EF4-FFF2-40B4-BE49-F238E27FC236}">
                <a16:creationId xmlns:a16="http://schemas.microsoft.com/office/drawing/2014/main" id="{C78188AF-F57D-DB8E-08A5-00C144CE0920}"/>
              </a:ext>
            </a:extLst>
          </p:cNvPr>
          <p:cNvSpPr/>
          <p:nvPr/>
        </p:nvSpPr>
        <p:spPr>
          <a:xfrm>
            <a:off x="541464" y="2736460"/>
            <a:ext cx="73609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Nes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70A9961B-63EE-2006-0CF5-F5D3C71DC8F8}"/>
              </a:ext>
            </a:extLst>
          </p:cNvPr>
          <p:cNvSpPr/>
          <p:nvPr/>
        </p:nvSpPr>
        <p:spPr>
          <a:xfrm>
            <a:off x="2363539" y="2728466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01DE25AE-A4F8-A129-6F87-F5A52C5D6895}"/>
              </a:ext>
            </a:extLst>
          </p:cNvPr>
          <p:cNvSpPr/>
          <p:nvPr/>
        </p:nvSpPr>
        <p:spPr>
          <a:xfrm>
            <a:off x="4289966" y="2728727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E023601D-C081-84D2-4B09-2A911D2E9B8B}"/>
              </a:ext>
            </a:extLst>
          </p:cNvPr>
          <p:cNvSpPr/>
          <p:nvPr/>
        </p:nvSpPr>
        <p:spPr>
          <a:xfrm>
            <a:off x="5760388" y="2789369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FE3FE6C5-D5B7-5FB1-8CC6-86C83554F2A9}"/>
              </a:ext>
            </a:extLst>
          </p:cNvPr>
          <p:cNvSpPr/>
          <p:nvPr/>
        </p:nvSpPr>
        <p:spPr>
          <a:xfrm>
            <a:off x="542594" y="5780202"/>
            <a:ext cx="73609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Nes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2DA1C388-A2F6-8292-DB07-0FE331373233}"/>
              </a:ext>
            </a:extLst>
          </p:cNvPr>
          <p:cNvSpPr/>
          <p:nvPr/>
        </p:nvSpPr>
        <p:spPr>
          <a:xfrm>
            <a:off x="2364669" y="5933187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3200F9B4-974C-5725-D98D-12E7E24E015C}"/>
              </a:ext>
            </a:extLst>
          </p:cNvPr>
          <p:cNvSpPr/>
          <p:nvPr/>
        </p:nvSpPr>
        <p:spPr>
          <a:xfrm>
            <a:off x="4316852" y="5894812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77F494E6-2F5B-089A-0A7D-BDC25F3D532E}"/>
              </a:ext>
            </a:extLst>
          </p:cNvPr>
          <p:cNvSpPr/>
          <p:nvPr/>
        </p:nvSpPr>
        <p:spPr>
          <a:xfrm>
            <a:off x="5851665" y="6077805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B0463F3C-7D7D-1330-B3B8-653EBED00CFB}"/>
              </a:ext>
            </a:extLst>
          </p:cNvPr>
          <p:cNvSpPr txBox="1"/>
          <p:nvPr/>
        </p:nvSpPr>
        <p:spPr>
          <a:xfrm>
            <a:off x="0" y="40579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1A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642202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177DB0-C236-47EB-9E61-B30E97BEF1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图片 69">
            <a:extLst>
              <a:ext uri="{FF2B5EF4-FFF2-40B4-BE49-F238E27FC236}">
                <a16:creationId xmlns:a16="http://schemas.microsoft.com/office/drawing/2014/main" id="{1DBB7013-2708-A487-68A3-4E26C22F28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294283" y="2682433"/>
            <a:ext cx="1821491" cy="2553056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2B6E9EB7-A921-3968-CBA6-5708A8D084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2388" y="5744549"/>
            <a:ext cx="1771897" cy="2514951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88DBDFE9-6BCC-CA4B-7A9A-0D15A45663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2218" y="2722916"/>
            <a:ext cx="1648055" cy="2305372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787EEEBF-1AF4-8FE5-5215-3AB3972036A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730" y="5744550"/>
            <a:ext cx="1924319" cy="251495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6DCDBCD-2353-DB2F-AF7E-6FD688B272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08836" y="5691544"/>
            <a:ext cx="1609950" cy="275310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81D6466-07B9-62C9-BBF5-7D3D33875CE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89784" y="2709239"/>
            <a:ext cx="1648055" cy="2191056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id="{AF01AABA-10AB-A83D-F28B-3B3BA65BD613}"/>
              </a:ext>
            </a:extLst>
          </p:cNvPr>
          <p:cNvGrpSpPr/>
          <p:nvPr/>
        </p:nvGrpSpPr>
        <p:grpSpPr>
          <a:xfrm>
            <a:off x="359399" y="896598"/>
            <a:ext cx="2302835" cy="1332211"/>
            <a:chOff x="122391" y="-61961"/>
            <a:chExt cx="2302835" cy="1332211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B9CA01C5-FC42-390F-8538-92F939930B2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7627" t="45331" r="37943" b="45019"/>
            <a:stretch/>
          </p:blipFill>
          <p:spPr>
            <a:xfrm>
              <a:off x="1540773" y="717099"/>
              <a:ext cx="876300" cy="265673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57064EEB-4CB5-947F-F5E4-3261A9F41F2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9152" t="46276" r="32195" b="40473"/>
            <a:stretch/>
          </p:blipFill>
          <p:spPr>
            <a:xfrm>
              <a:off x="630658" y="717129"/>
              <a:ext cx="887939" cy="266701"/>
            </a:xfrm>
            <a:prstGeom prst="rect">
              <a:avLst/>
            </a:prstGeom>
          </p:spPr>
        </p:pic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628D9B68-FDA7-B82B-C36A-5AC2EFFB9881}"/>
                </a:ext>
              </a:extLst>
            </p:cNvPr>
            <p:cNvGrpSpPr/>
            <p:nvPr/>
          </p:nvGrpSpPr>
          <p:grpSpPr>
            <a:xfrm>
              <a:off x="122391" y="-61961"/>
              <a:ext cx="2302835" cy="1332211"/>
              <a:chOff x="160491" y="1691592"/>
              <a:chExt cx="2302835" cy="1332211"/>
            </a:xfrm>
          </p:grpSpPr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38C3C472-34B2-9F1A-77E6-41DBD26E6B85}"/>
                  </a:ext>
                </a:extLst>
              </p:cNvPr>
              <p:cNvSpPr/>
              <p:nvPr/>
            </p:nvSpPr>
            <p:spPr>
              <a:xfrm>
                <a:off x="160491" y="1946562"/>
                <a:ext cx="56778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RIN2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B0F0735F-5847-907F-01C0-FD6310196847}"/>
                  </a:ext>
                </a:extLst>
              </p:cNvPr>
              <p:cNvSpPr/>
              <p:nvPr/>
            </p:nvSpPr>
            <p:spPr>
              <a:xfrm>
                <a:off x="239038" y="2222558"/>
                <a:ext cx="4892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D4B96324-AB36-A8C2-EA9B-022D5B404B84}"/>
                  </a:ext>
                </a:extLst>
              </p:cNvPr>
              <p:cNvSpPr/>
              <p:nvPr/>
            </p:nvSpPr>
            <p:spPr>
              <a:xfrm>
                <a:off x="182047" y="2498627"/>
                <a:ext cx="55015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078D3F05-4DC2-2A81-59A0-C8E862009DBC}"/>
                  </a:ext>
                </a:extLst>
              </p:cNvPr>
              <p:cNvSpPr/>
              <p:nvPr/>
            </p:nvSpPr>
            <p:spPr>
              <a:xfrm rot="18900000">
                <a:off x="484090" y="2794092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BDCFD78F-F71B-1EB0-3978-FC7EB5E7C587}"/>
                  </a:ext>
                </a:extLst>
              </p:cNvPr>
              <p:cNvSpPr/>
              <p:nvPr/>
            </p:nvSpPr>
            <p:spPr>
              <a:xfrm rot="18900000">
                <a:off x="695621" y="2804394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D34FE2D8-7A14-2D60-1C54-3819F57F4E7A}"/>
                  </a:ext>
                </a:extLst>
              </p:cNvPr>
              <p:cNvSpPr/>
              <p:nvPr/>
            </p:nvSpPr>
            <p:spPr>
              <a:xfrm rot="18900000">
                <a:off x="941734" y="2808358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4E507ABA-6079-1122-CAA0-D403D663C587}"/>
                  </a:ext>
                </a:extLst>
              </p:cNvPr>
              <p:cNvSpPr/>
              <p:nvPr/>
            </p:nvSpPr>
            <p:spPr>
              <a:xfrm rot="18900000">
                <a:off x="1394466" y="2793034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FD076EEF-B50E-2EDB-4CDD-1345BCD2FBD8}"/>
                  </a:ext>
                </a:extLst>
              </p:cNvPr>
              <p:cNvSpPr/>
              <p:nvPr/>
            </p:nvSpPr>
            <p:spPr>
              <a:xfrm rot="18900000">
                <a:off x="1623588" y="2808359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2A0D32FC-9693-E03C-3941-F96AAECE40F8}"/>
                  </a:ext>
                </a:extLst>
              </p:cNvPr>
              <p:cNvSpPr/>
              <p:nvPr/>
            </p:nvSpPr>
            <p:spPr>
              <a:xfrm rot="18900000">
                <a:off x="1887527" y="2808358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3CEA9C29-A131-2EEC-5085-946889EE7B85}"/>
                  </a:ext>
                </a:extLst>
              </p:cNvPr>
              <p:cNvSpPr/>
              <p:nvPr/>
            </p:nvSpPr>
            <p:spPr>
              <a:xfrm>
                <a:off x="893605" y="1699895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4A224226-01B3-7FE2-50BB-271CFC7A777D}"/>
                  </a:ext>
                </a:extLst>
              </p:cNvPr>
              <p:cNvSpPr/>
              <p:nvPr/>
            </p:nvSpPr>
            <p:spPr>
              <a:xfrm>
                <a:off x="1882598" y="1691592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2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6D25A252-8F99-EF43-1429-F485E10C439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8439" t="42023" r="32391" b="47571"/>
            <a:stretch/>
          </p:blipFill>
          <p:spPr>
            <a:xfrm flipH="1">
              <a:off x="622987" y="444069"/>
              <a:ext cx="895610" cy="265672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3F4CACC-7ADE-7847-3E93-8C24AC7E266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4197" t="43513" r="26348" b="45923"/>
            <a:stretch/>
          </p:blipFill>
          <p:spPr>
            <a:xfrm>
              <a:off x="1540773" y="442051"/>
              <a:ext cx="876300" cy="265673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D5FC9E03-3F5E-1D44-B336-F2D316C12AE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2110" t="19461" r="23851" b="69015"/>
            <a:stretch/>
          </p:blipFill>
          <p:spPr>
            <a:xfrm>
              <a:off x="628008" y="171009"/>
              <a:ext cx="890589" cy="265672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D6262F62-98CF-3049-26DC-3C5ADE36CDD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22717" t="19837" r="31745" b="69599"/>
            <a:stretch/>
          </p:blipFill>
          <p:spPr>
            <a:xfrm>
              <a:off x="1546506" y="171009"/>
              <a:ext cx="876300" cy="265673"/>
            </a:xfrm>
            <a:prstGeom prst="rect">
              <a:avLst/>
            </a:prstGeom>
          </p:spPr>
        </p:pic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9635F4DD-F5DD-FABA-8120-25642140B9BB}"/>
              </a:ext>
            </a:extLst>
          </p:cNvPr>
          <p:cNvSpPr/>
          <p:nvPr/>
        </p:nvSpPr>
        <p:spPr>
          <a:xfrm>
            <a:off x="777153" y="2506673"/>
            <a:ext cx="8274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1D118086-57FD-1695-1A5C-F2F476C3560D}"/>
              </a:ext>
            </a:extLst>
          </p:cNvPr>
          <p:cNvSpPr/>
          <p:nvPr/>
        </p:nvSpPr>
        <p:spPr>
          <a:xfrm>
            <a:off x="2828788" y="2465263"/>
            <a:ext cx="74892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402B089F-A343-94E1-F7FE-ED43BB2023A9}"/>
              </a:ext>
            </a:extLst>
          </p:cNvPr>
          <p:cNvSpPr/>
          <p:nvPr/>
        </p:nvSpPr>
        <p:spPr>
          <a:xfrm>
            <a:off x="4808892" y="2493795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13BDD969-2661-AC37-1206-45BE58C16BF4}"/>
              </a:ext>
            </a:extLst>
          </p:cNvPr>
          <p:cNvSpPr/>
          <p:nvPr/>
        </p:nvSpPr>
        <p:spPr>
          <a:xfrm>
            <a:off x="750789" y="5519481"/>
            <a:ext cx="8274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F2D8F88-2357-420B-887C-5949BD95373F}"/>
              </a:ext>
            </a:extLst>
          </p:cNvPr>
          <p:cNvSpPr/>
          <p:nvPr/>
        </p:nvSpPr>
        <p:spPr>
          <a:xfrm>
            <a:off x="2802424" y="5516705"/>
            <a:ext cx="74892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AF36587-9E93-68C6-91C1-3B681764083A}"/>
              </a:ext>
            </a:extLst>
          </p:cNvPr>
          <p:cNvSpPr/>
          <p:nvPr/>
        </p:nvSpPr>
        <p:spPr>
          <a:xfrm>
            <a:off x="4782528" y="5467969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CF31A54-9A4D-68A3-3879-E80FD775715F}"/>
              </a:ext>
            </a:extLst>
          </p:cNvPr>
          <p:cNvSpPr txBox="1"/>
          <p:nvPr/>
        </p:nvSpPr>
        <p:spPr>
          <a:xfrm>
            <a:off x="104245" y="112360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1B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38029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19DBD8B2-2A78-FAF3-C38C-685B02A0D9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794627" y="6525381"/>
            <a:ext cx="1543265" cy="2143424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D485964A-C7CD-09BF-9ADB-08AFFD0BA0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81488" y="3506705"/>
            <a:ext cx="1629002" cy="229584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AE85FB6-ACBB-DCCF-D9F2-3087E2D9E4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55585" y="3596818"/>
            <a:ext cx="2105319" cy="211484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9E00E26-A4A6-73C8-83DB-6D223BD871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51453" y="6589391"/>
            <a:ext cx="2038635" cy="207674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86DA7919-BCCF-FD19-1423-6749ECB821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74071" y="3582529"/>
            <a:ext cx="1952898" cy="214342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D055D7FA-0921-BAC6-3C60-57EFFC45D9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08695" y="6527603"/>
            <a:ext cx="2033796" cy="2172003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BB7E39B8-EB90-9231-D2C2-1F8C6E2B1AE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3131554" y="3569675"/>
            <a:ext cx="2020821" cy="2419688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33A44E57-ADB3-89F4-2CA2-A299D62CB1B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69849" y="6525381"/>
            <a:ext cx="2229161" cy="2238687"/>
          </a:xfrm>
          <a:prstGeom prst="rect">
            <a:avLst/>
          </a:prstGeom>
        </p:spPr>
      </p:pic>
      <p:grpSp>
        <p:nvGrpSpPr>
          <p:cNvPr id="52" name="组合 51">
            <a:extLst>
              <a:ext uri="{FF2B5EF4-FFF2-40B4-BE49-F238E27FC236}">
                <a16:creationId xmlns:a16="http://schemas.microsoft.com/office/drawing/2014/main" id="{4E608B85-8FC7-A1B9-B52E-986FB29B441B}"/>
              </a:ext>
            </a:extLst>
          </p:cNvPr>
          <p:cNvGrpSpPr/>
          <p:nvPr/>
        </p:nvGrpSpPr>
        <p:grpSpPr>
          <a:xfrm>
            <a:off x="356254" y="982394"/>
            <a:ext cx="3000768" cy="1729395"/>
            <a:chOff x="627317" y="563499"/>
            <a:chExt cx="3000768" cy="1729395"/>
          </a:xfrm>
        </p:grpSpPr>
        <p:grpSp>
          <p:nvGrpSpPr>
            <p:cNvPr id="24" name="组合 23"/>
            <p:cNvGrpSpPr/>
            <p:nvPr/>
          </p:nvGrpSpPr>
          <p:grpSpPr>
            <a:xfrm>
              <a:off x="627317" y="563499"/>
              <a:ext cx="3000768" cy="1729395"/>
              <a:chOff x="3319097" y="-30056"/>
              <a:chExt cx="3000768" cy="1729395"/>
            </a:xfrm>
          </p:grpSpPr>
          <p:sp>
            <p:nvSpPr>
              <p:cNvPr id="6" name="矩形 5"/>
              <p:cNvSpPr/>
              <p:nvPr/>
            </p:nvSpPr>
            <p:spPr>
              <a:xfrm>
                <a:off x="3482604" y="189968"/>
                <a:ext cx="56778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RIN2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矩形 6"/>
              <p:cNvSpPr/>
              <p:nvPr/>
            </p:nvSpPr>
            <p:spPr>
              <a:xfrm>
                <a:off x="4361361" y="-30056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3319097" y="453420"/>
                <a:ext cx="73129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l-GR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-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 III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>
                <a:off x="3544287" y="731493"/>
                <a:ext cx="46519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FAP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矩形 9"/>
              <p:cNvSpPr/>
              <p:nvPr/>
            </p:nvSpPr>
            <p:spPr>
              <a:xfrm>
                <a:off x="3499079" y="995796"/>
                <a:ext cx="55015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5474124" y="-30056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2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 rot="18900000">
                <a:off x="3816990" y="1283701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矩形 12"/>
              <p:cNvSpPr/>
              <p:nvPr/>
            </p:nvSpPr>
            <p:spPr>
              <a:xfrm rot="18900000">
                <a:off x="4004699" y="1304670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矩形 13"/>
              <p:cNvSpPr/>
              <p:nvPr/>
            </p:nvSpPr>
            <p:spPr>
              <a:xfrm rot="18900000">
                <a:off x="3906337" y="1450118"/>
                <a:ext cx="99097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Vector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/>
              <p:cNvSpPr/>
              <p:nvPr/>
            </p:nvSpPr>
            <p:spPr>
              <a:xfrm rot="18900000">
                <a:off x="4123261" y="1483895"/>
                <a:ext cx="107593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>
                    <a:latin typeface="Arial" panose="020B0604020202020204" pitchFamily="34" charset="0"/>
                    <a:cs typeface="Arial" panose="020B0604020202020204" pitchFamily="34" charset="0"/>
                  </a:rPr>
                  <a:t>Sevo ×3 + GRIN2B</a:t>
                </a:r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矩形 43"/>
              <p:cNvSpPr/>
              <p:nvPr/>
            </p:nvSpPr>
            <p:spPr>
              <a:xfrm rot="18900000">
                <a:off x="4936227" y="1289920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矩形 44"/>
              <p:cNvSpPr/>
              <p:nvPr/>
            </p:nvSpPr>
            <p:spPr>
              <a:xfrm rot="18900000">
                <a:off x="5130927" y="1310888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矩形 45"/>
              <p:cNvSpPr/>
              <p:nvPr/>
            </p:nvSpPr>
            <p:spPr>
              <a:xfrm rot="18900000">
                <a:off x="5033333" y="1450117"/>
                <a:ext cx="99097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Vector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矩形 46"/>
              <p:cNvSpPr/>
              <p:nvPr/>
            </p:nvSpPr>
            <p:spPr>
              <a:xfrm rot="18900000">
                <a:off x="5243928" y="1480155"/>
                <a:ext cx="107593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>
                    <a:latin typeface="Arial" panose="020B0604020202020204" pitchFamily="34" charset="0"/>
                    <a:cs typeface="Arial" panose="020B0604020202020204" pitchFamily="34" charset="0"/>
                  </a:rPr>
                  <a:t>Sevo ×3 + GRIN2B</a:t>
                </a:r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49ED1255-49C9-6F4D-C14C-716B0E0B2AF3}"/>
                </a:ext>
              </a:extLst>
            </p:cNvPr>
            <p:cNvGrpSpPr/>
            <p:nvPr/>
          </p:nvGrpSpPr>
          <p:grpSpPr>
            <a:xfrm>
              <a:off x="1294710" y="733235"/>
              <a:ext cx="2220509" cy="1093488"/>
              <a:chOff x="4378459" y="1996733"/>
              <a:chExt cx="2220509" cy="1093488"/>
            </a:xfrm>
          </p:grpSpPr>
          <p:grpSp>
            <p:nvGrpSpPr>
              <p:cNvPr id="50" name="组合 49">
                <a:extLst>
                  <a:ext uri="{FF2B5EF4-FFF2-40B4-BE49-F238E27FC236}">
                    <a16:creationId xmlns:a16="http://schemas.microsoft.com/office/drawing/2014/main" id="{75AF2A60-DC6C-DE2A-65F9-D7D7F65EE65A}"/>
                  </a:ext>
                </a:extLst>
              </p:cNvPr>
              <p:cNvGrpSpPr/>
              <p:nvPr/>
            </p:nvGrpSpPr>
            <p:grpSpPr>
              <a:xfrm>
                <a:off x="5504448" y="1998334"/>
                <a:ext cx="1094520" cy="1091887"/>
                <a:chOff x="5347705" y="427747"/>
                <a:chExt cx="1094520" cy="1091887"/>
              </a:xfrm>
            </p:grpSpPr>
            <p:pic>
              <p:nvPicPr>
                <p:cNvPr id="34" name="图片 33">
                  <a:extLst>
                    <a:ext uri="{FF2B5EF4-FFF2-40B4-BE49-F238E27FC236}">
                      <a16:creationId xmlns:a16="http://schemas.microsoft.com/office/drawing/2014/main" id="{205D0D17-5AC5-3D42-6B5B-975D76648A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rcRect l="13547" t="43164" r="30495" b="43777"/>
                <a:stretch/>
              </p:blipFill>
              <p:spPr>
                <a:xfrm>
                  <a:off x="5347705" y="1259426"/>
                  <a:ext cx="1094519" cy="260208"/>
                </a:xfrm>
                <a:prstGeom prst="rect">
                  <a:avLst/>
                </a:prstGeom>
              </p:spPr>
            </p:pic>
            <p:pic>
              <p:nvPicPr>
                <p:cNvPr id="48" name="图片 47">
                  <a:extLst>
                    <a:ext uri="{FF2B5EF4-FFF2-40B4-BE49-F238E27FC236}">
                      <a16:creationId xmlns:a16="http://schemas.microsoft.com/office/drawing/2014/main" id="{373B9665-C023-6103-78B0-E92C8A27A6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rcRect l="35352" t="27176" r="11719" b="60033"/>
                <a:stretch/>
              </p:blipFill>
              <p:spPr>
                <a:xfrm>
                  <a:off x="5347705" y="976608"/>
                  <a:ext cx="1094519" cy="265633"/>
                </a:xfrm>
                <a:prstGeom prst="rect">
                  <a:avLst/>
                </a:prstGeom>
              </p:spPr>
            </p:pic>
            <p:pic>
              <p:nvPicPr>
                <p:cNvPr id="38" name="图片 37">
                  <a:extLst>
                    <a:ext uri="{FF2B5EF4-FFF2-40B4-BE49-F238E27FC236}">
                      <a16:creationId xmlns:a16="http://schemas.microsoft.com/office/drawing/2014/main" id="{FBE11FA6-F6F1-658E-6383-99B8BCF3CC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rcRect l="34964" t="27501" r="11219" b="60519"/>
                <a:stretch/>
              </p:blipFill>
              <p:spPr>
                <a:xfrm>
                  <a:off x="5347706" y="702178"/>
                  <a:ext cx="1094519" cy="260208"/>
                </a:xfrm>
                <a:prstGeom prst="rect">
                  <a:avLst/>
                </a:prstGeom>
              </p:spPr>
            </p:pic>
            <p:pic>
              <p:nvPicPr>
                <p:cNvPr id="31" name="图片 30">
                  <a:extLst>
                    <a:ext uri="{FF2B5EF4-FFF2-40B4-BE49-F238E27FC236}">
                      <a16:creationId xmlns:a16="http://schemas.microsoft.com/office/drawing/2014/main" id="{4F77D3C7-FF47-1467-2406-CEC7BE01EA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rcRect l="14044" t="19537" r="14294" b="69030"/>
                <a:stretch/>
              </p:blipFill>
              <p:spPr>
                <a:xfrm>
                  <a:off x="5347706" y="427747"/>
                  <a:ext cx="1094519" cy="260209"/>
                </a:xfrm>
                <a:prstGeom prst="rect">
                  <a:avLst/>
                </a:prstGeom>
              </p:spPr>
            </p:pic>
          </p:grpSp>
          <p:grpSp>
            <p:nvGrpSpPr>
              <p:cNvPr id="49" name="组合 48">
                <a:extLst>
                  <a:ext uri="{FF2B5EF4-FFF2-40B4-BE49-F238E27FC236}">
                    <a16:creationId xmlns:a16="http://schemas.microsoft.com/office/drawing/2014/main" id="{AFBC8CAC-B29A-2BFD-F17F-6786E88CF4AB}"/>
                  </a:ext>
                </a:extLst>
              </p:cNvPr>
              <p:cNvGrpSpPr/>
              <p:nvPr/>
            </p:nvGrpSpPr>
            <p:grpSpPr>
              <a:xfrm>
                <a:off x="4378459" y="1996733"/>
                <a:ext cx="1094521" cy="1089885"/>
                <a:chOff x="4140082" y="446141"/>
                <a:chExt cx="1094521" cy="1089885"/>
              </a:xfrm>
            </p:grpSpPr>
            <p:pic>
              <p:nvPicPr>
                <p:cNvPr id="33" name="图片 32">
                  <a:extLst>
                    <a:ext uri="{FF2B5EF4-FFF2-40B4-BE49-F238E27FC236}">
                      <a16:creationId xmlns:a16="http://schemas.microsoft.com/office/drawing/2014/main" id="{6C69368E-60DF-85E2-B5A8-4CDA8FDD7C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 l="9232" t="38829" r="36014" b="47942"/>
                <a:stretch/>
              </p:blipFill>
              <p:spPr>
                <a:xfrm>
                  <a:off x="4140082" y="1270393"/>
                  <a:ext cx="1094519" cy="265633"/>
                </a:xfrm>
                <a:prstGeom prst="rect">
                  <a:avLst/>
                </a:prstGeom>
              </p:spPr>
            </p:pic>
            <p:pic>
              <p:nvPicPr>
                <p:cNvPr id="39" name="图片 38">
                  <a:extLst>
                    <a:ext uri="{FF2B5EF4-FFF2-40B4-BE49-F238E27FC236}">
                      <a16:creationId xmlns:a16="http://schemas.microsoft.com/office/drawing/2014/main" id="{5AE2901F-94E3-54F1-E823-BFFD70855E3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rcRect l="32074" t="29900" r="8783" b="58112"/>
                <a:stretch/>
              </p:blipFill>
              <p:spPr>
                <a:xfrm flipH="1">
                  <a:off x="4140083" y="996603"/>
                  <a:ext cx="1094519" cy="265632"/>
                </a:xfrm>
                <a:prstGeom prst="rect">
                  <a:avLst/>
                </a:prstGeom>
              </p:spPr>
            </p:pic>
            <p:pic>
              <p:nvPicPr>
                <p:cNvPr id="35" name="图片 34">
                  <a:extLst>
                    <a:ext uri="{FF2B5EF4-FFF2-40B4-BE49-F238E27FC236}">
                      <a16:creationId xmlns:a16="http://schemas.microsoft.com/office/drawing/2014/main" id="{9B58E254-E1CA-2D22-ED11-0BBB561677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rcRect l="28825" t="31473" r="12477" b="55548"/>
                <a:stretch/>
              </p:blipFill>
              <p:spPr>
                <a:xfrm>
                  <a:off x="4140083" y="722813"/>
                  <a:ext cx="1094519" cy="265632"/>
                </a:xfrm>
                <a:prstGeom prst="rect">
                  <a:avLst/>
                </a:prstGeom>
              </p:spPr>
            </p:pic>
            <p:pic>
              <p:nvPicPr>
                <p:cNvPr id="32" name="图片 31">
                  <a:extLst>
                    <a:ext uri="{FF2B5EF4-FFF2-40B4-BE49-F238E27FC236}">
                      <a16:creationId xmlns:a16="http://schemas.microsoft.com/office/drawing/2014/main" id="{B5B3B426-6D6A-672F-04DF-D8E37034E75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rcRect l="18346" t="21231" r="14464" b="67198"/>
                <a:stretch/>
              </p:blipFill>
              <p:spPr>
                <a:xfrm>
                  <a:off x="4140084" y="446141"/>
                  <a:ext cx="1094519" cy="265632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59880E18-BB57-059A-C99C-9B4A6074A735}"/>
              </a:ext>
            </a:extLst>
          </p:cNvPr>
          <p:cNvSpPr/>
          <p:nvPr/>
        </p:nvSpPr>
        <p:spPr>
          <a:xfrm>
            <a:off x="-278525" y="3291261"/>
            <a:ext cx="82747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54F1E959-079E-BCE8-E16A-491F5A187AFE}"/>
              </a:ext>
            </a:extLst>
          </p:cNvPr>
          <p:cNvSpPr/>
          <p:nvPr/>
        </p:nvSpPr>
        <p:spPr>
          <a:xfrm>
            <a:off x="1581741" y="3366215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051B9EA7-745F-2638-8E29-D3AE858CBBB9}"/>
              </a:ext>
            </a:extLst>
          </p:cNvPr>
          <p:cNvSpPr/>
          <p:nvPr/>
        </p:nvSpPr>
        <p:spPr>
          <a:xfrm>
            <a:off x="3724105" y="3349991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CB727548-5CEF-B3A3-0960-43850E8ED9E4}"/>
              </a:ext>
            </a:extLst>
          </p:cNvPr>
          <p:cNvSpPr/>
          <p:nvPr/>
        </p:nvSpPr>
        <p:spPr>
          <a:xfrm>
            <a:off x="5935487" y="3371915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527D9E24-0F84-2EE1-1F4E-2711728E2A25}"/>
              </a:ext>
            </a:extLst>
          </p:cNvPr>
          <p:cNvSpPr/>
          <p:nvPr/>
        </p:nvSpPr>
        <p:spPr>
          <a:xfrm>
            <a:off x="1439762" y="6301577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A62F9F3E-1460-8DFE-3869-D31BA36A9247}"/>
              </a:ext>
            </a:extLst>
          </p:cNvPr>
          <p:cNvSpPr/>
          <p:nvPr/>
        </p:nvSpPr>
        <p:spPr>
          <a:xfrm>
            <a:off x="3724105" y="6298161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378B6CED-D862-C1C2-A715-4F09F0E1FF56}"/>
              </a:ext>
            </a:extLst>
          </p:cNvPr>
          <p:cNvSpPr/>
          <p:nvPr/>
        </p:nvSpPr>
        <p:spPr>
          <a:xfrm>
            <a:off x="6046222" y="6378251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6E66429A-F2F6-DDE3-B5B0-C15C2368E30F}"/>
              </a:ext>
            </a:extLst>
          </p:cNvPr>
          <p:cNvSpPr/>
          <p:nvPr/>
        </p:nvSpPr>
        <p:spPr>
          <a:xfrm>
            <a:off x="-436731" y="6311454"/>
            <a:ext cx="8274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EEF2CCA-59D6-B9ED-9D4A-7A6FFAF12F9C}"/>
              </a:ext>
            </a:extLst>
          </p:cNvPr>
          <p:cNvSpPr txBox="1"/>
          <p:nvPr/>
        </p:nvSpPr>
        <p:spPr>
          <a:xfrm>
            <a:off x="104245" y="112360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3B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284210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EA9963B-37DF-765A-C200-6742CBFDDE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5456" y="3011124"/>
            <a:ext cx="1648055" cy="2314898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699DD230-1A06-541A-648B-2346DBBC8F59}"/>
              </a:ext>
            </a:extLst>
          </p:cNvPr>
          <p:cNvSpPr/>
          <p:nvPr/>
        </p:nvSpPr>
        <p:spPr>
          <a:xfrm>
            <a:off x="4121934" y="2782519"/>
            <a:ext cx="73129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6D715DA1-8003-8B81-7EAC-7FF47152D2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5603" y="5718352"/>
            <a:ext cx="2248214" cy="2486372"/>
          </a:xfrm>
          <a:prstGeom prst="rect">
            <a:avLst/>
          </a:prstGeom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CD4E2D67-F1C0-783D-36A4-115E64FF9BFE}"/>
              </a:ext>
            </a:extLst>
          </p:cNvPr>
          <p:cNvSpPr/>
          <p:nvPr/>
        </p:nvSpPr>
        <p:spPr>
          <a:xfrm>
            <a:off x="1807910" y="5491395"/>
            <a:ext cx="46519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7B491EEB-6C79-9E52-0873-B930082A69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4157" y="3160192"/>
            <a:ext cx="1752845" cy="2172003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A5DF36D9-5FB5-6BC7-A2E7-FA51014E237A}"/>
              </a:ext>
            </a:extLst>
          </p:cNvPr>
          <p:cNvSpPr/>
          <p:nvPr/>
        </p:nvSpPr>
        <p:spPr>
          <a:xfrm>
            <a:off x="1897221" y="2939595"/>
            <a:ext cx="56778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F4B0CFB2-1AA0-7144-8606-02DAC37207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3742" y="5894589"/>
            <a:ext cx="2267266" cy="2133898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DF5C4E4A-D2CC-E01B-D88A-D8F8246FB8CF}"/>
              </a:ext>
            </a:extLst>
          </p:cNvPr>
          <p:cNvSpPr/>
          <p:nvPr/>
        </p:nvSpPr>
        <p:spPr>
          <a:xfrm>
            <a:off x="4329236" y="5679145"/>
            <a:ext cx="55015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1FBE1DB8-57DD-1969-2097-CDD020623467}"/>
              </a:ext>
            </a:extLst>
          </p:cNvPr>
          <p:cNvGrpSpPr/>
          <p:nvPr/>
        </p:nvGrpSpPr>
        <p:grpSpPr>
          <a:xfrm>
            <a:off x="184313" y="639294"/>
            <a:ext cx="1955256" cy="1904397"/>
            <a:chOff x="180708" y="-161795"/>
            <a:chExt cx="1955256" cy="1904397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22AE8995-0248-0A30-7389-9C69BD30D25D}"/>
                </a:ext>
              </a:extLst>
            </p:cNvPr>
            <p:cNvGrpSpPr/>
            <p:nvPr/>
          </p:nvGrpSpPr>
          <p:grpSpPr>
            <a:xfrm>
              <a:off x="180708" y="-161795"/>
              <a:ext cx="1955256" cy="1904397"/>
              <a:chOff x="41574" y="7456303"/>
              <a:chExt cx="1955256" cy="1904397"/>
            </a:xfrm>
          </p:grpSpPr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539653E5-8AC5-9077-4347-3A1CF0FBABBB}"/>
                  </a:ext>
                </a:extLst>
              </p:cNvPr>
              <p:cNvSpPr/>
              <p:nvPr/>
            </p:nvSpPr>
            <p:spPr>
              <a:xfrm>
                <a:off x="192083" y="7685310"/>
                <a:ext cx="56778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RIN2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348350F1-6D52-A9A4-AE7B-AD4568585BFE}"/>
                  </a:ext>
                </a:extLst>
              </p:cNvPr>
              <p:cNvSpPr/>
              <p:nvPr/>
            </p:nvSpPr>
            <p:spPr>
              <a:xfrm>
                <a:off x="1155286" y="7456303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8 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矩形 12">
                <a:extLst>
                  <a:ext uri="{FF2B5EF4-FFF2-40B4-BE49-F238E27FC236}">
                    <a16:creationId xmlns:a16="http://schemas.microsoft.com/office/drawing/2014/main" id="{3A4EF8D1-6F17-6649-17B9-C9D5EE3083A9}"/>
                  </a:ext>
                </a:extLst>
              </p:cNvPr>
              <p:cNvSpPr/>
              <p:nvPr/>
            </p:nvSpPr>
            <p:spPr>
              <a:xfrm>
                <a:off x="41574" y="8006638"/>
                <a:ext cx="73129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l-GR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-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 III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1ED163B5-CDA5-86FF-0C22-6430B8365011}"/>
                  </a:ext>
                </a:extLst>
              </p:cNvPr>
              <p:cNvSpPr/>
              <p:nvPr/>
            </p:nvSpPr>
            <p:spPr>
              <a:xfrm>
                <a:off x="294674" y="8314616"/>
                <a:ext cx="4651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FAP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F49189F8-ED12-C59B-4544-E1808D59CD77}"/>
                  </a:ext>
                </a:extLst>
              </p:cNvPr>
              <p:cNvSpPr/>
              <p:nvPr/>
            </p:nvSpPr>
            <p:spPr>
              <a:xfrm>
                <a:off x="222713" y="8636234"/>
                <a:ext cx="55015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06D204B1-8DCD-A77A-ACD2-30B734F0E0A9}"/>
                  </a:ext>
                </a:extLst>
              </p:cNvPr>
              <p:cNvSpPr/>
              <p:nvPr/>
            </p:nvSpPr>
            <p:spPr>
              <a:xfrm rot="18900000">
                <a:off x="549851" y="8944690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A8997613-447D-C6FF-4B3C-7423D5BCBE3E}"/>
                  </a:ext>
                </a:extLst>
              </p:cNvPr>
              <p:cNvSpPr/>
              <p:nvPr/>
            </p:nvSpPr>
            <p:spPr>
              <a:xfrm rot="18900000">
                <a:off x="811324" y="8970585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B4F4503D-FEC1-79BB-9846-FA4A46226468}"/>
                  </a:ext>
                </a:extLst>
              </p:cNvPr>
              <p:cNvSpPr/>
              <p:nvPr/>
            </p:nvSpPr>
            <p:spPr>
              <a:xfrm rot="18900000">
                <a:off x="703910" y="9128439"/>
                <a:ext cx="99097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Vector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D1B25278-A85A-6CDA-0128-AA2110C1B26A}"/>
                  </a:ext>
                </a:extLst>
              </p:cNvPr>
              <p:cNvSpPr/>
              <p:nvPr/>
            </p:nvSpPr>
            <p:spPr>
              <a:xfrm rot="18900000">
                <a:off x="920893" y="9145256"/>
                <a:ext cx="107593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>
                    <a:latin typeface="Arial" panose="020B0604020202020204" pitchFamily="34" charset="0"/>
                    <a:cs typeface="Arial" panose="020B0604020202020204" pitchFamily="34" charset="0"/>
                  </a:rPr>
                  <a:t>Sevo ×3 + GRIN2B</a:t>
                </a:r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7B2BB9F8-8796-79AA-B726-37F14A89DDB8}"/>
                </a:ext>
              </a:extLst>
            </p:cNvPr>
            <p:cNvGrpSpPr/>
            <p:nvPr/>
          </p:nvGrpSpPr>
          <p:grpSpPr>
            <a:xfrm>
              <a:off x="876767" y="29505"/>
              <a:ext cx="1188722" cy="1237626"/>
              <a:chOff x="-901257" y="1835137"/>
              <a:chExt cx="1188722" cy="1237626"/>
            </a:xfrm>
          </p:grpSpPr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CEA76D35-6A1D-7433-5514-EEEF938025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10249" t="54488" r="37321" b="31585"/>
              <a:stretch/>
            </p:blipFill>
            <p:spPr>
              <a:xfrm>
                <a:off x="-901257" y="2775581"/>
                <a:ext cx="1188721" cy="297182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B336805C-DC03-37AF-6813-730D8B89D0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31635" t="48965" r="15491" b="39083"/>
              <a:stretch/>
            </p:blipFill>
            <p:spPr>
              <a:xfrm>
                <a:off x="-901256" y="2462410"/>
                <a:ext cx="1188720" cy="297181"/>
              </a:xfrm>
              <a:prstGeom prst="rect">
                <a:avLst/>
              </a:prstGeom>
            </p:spPr>
          </p:pic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F108FBBE-D769-5C8F-2A0A-3B5F3B8A3D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24541" t="15885" r="10851" b="71080"/>
              <a:stretch/>
            </p:blipFill>
            <p:spPr>
              <a:xfrm>
                <a:off x="-901256" y="1835137"/>
                <a:ext cx="1188721" cy="297181"/>
              </a:xfrm>
              <a:prstGeom prst="rect">
                <a:avLst/>
              </a:prstGeom>
            </p:spPr>
          </p:pic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65A71022-D4DD-5773-2666-CDFBCB6CB3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12535" t="40927" r="15336" b="46235"/>
              <a:stretch/>
            </p:blipFill>
            <p:spPr>
              <a:xfrm>
                <a:off x="-901255" y="2148308"/>
                <a:ext cx="1188720" cy="297181"/>
              </a:xfrm>
              <a:prstGeom prst="rect">
                <a:avLst/>
              </a:prstGeom>
            </p:spPr>
          </p:pic>
        </p:grp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D439CF75-3297-7A7F-24D7-1A59A768CA13}"/>
              </a:ext>
            </a:extLst>
          </p:cNvPr>
          <p:cNvSpPr txBox="1"/>
          <p:nvPr/>
        </p:nvSpPr>
        <p:spPr>
          <a:xfrm>
            <a:off x="104245" y="73171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3F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11408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图片 102">
            <a:extLst>
              <a:ext uri="{FF2B5EF4-FFF2-40B4-BE49-F238E27FC236}">
                <a16:creationId xmlns:a16="http://schemas.microsoft.com/office/drawing/2014/main" id="{7A66C191-1E84-2C18-499D-9BB5A638A7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322607" y="3136166"/>
            <a:ext cx="1857634" cy="2257740"/>
          </a:xfrm>
          <a:prstGeom prst="rect">
            <a:avLst/>
          </a:prstGeom>
        </p:spPr>
      </p:pic>
      <p:pic>
        <p:nvPicPr>
          <p:cNvPr id="118" name="图片 117">
            <a:extLst>
              <a:ext uri="{FF2B5EF4-FFF2-40B4-BE49-F238E27FC236}">
                <a16:creationId xmlns:a16="http://schemas.microsoft.com/office/drawing/2014/main" id="{02A5ABA1-0903-8DEC-F62F-2E05BA8872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2459" y="3242943"/>
            <a:ext cx="2076740" cy="2162477"/>
          </a:xfrm>
          <a:prstGeom prst="rect">
            <a:avLst/>
          </a:prstGeom>
        </p:spPr>
      </p:pic>
      <p:pic>
        <p:nvPicPr>
          <p:cNvPr id="165" name="图片 164">
            <a:extLst>
              <a:ext uri="{FF2B5EF4-FFF2-40B4-BE49-F238E27FC236}">
                <a16:creationId xmlns:a16="http://schemas.microsoft.com/office/drawing/2014/main" id="{3C30752F-A2BD-A9D5-7AE7-E5881ABFA65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04909" y="5943900"/>
            <a:ext cx="2819794" cy="2133898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2B21E7B-0DB8-FC9B-B30F-E3D147CC19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324625" y="5984419"/>
            <a:ext cx="1667108" cy="196242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D310CE6-4262-8D3C-B772-25ACACACB3C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0736" y="5889186"/>
            <a:ext cx="2267266" cy="215295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B6EED54-13E5-7117-CD68-E81B05AD81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08960" y="5943900"/>
            <a:ext cx="2067213" cy="2105319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8EF39F5F-C113-5A92-E5B5-DC074FD469C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70399" y="3212377"/>
            <a:ext cx="1952898" cy="218152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7A32DA14-5654-36C6-940E-F044FCC2D62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1746" y="3141300"/>
            <a:ext cx="2314898" cy="2162477"/>
          </a:xfrm>
          <a:prstGeom prst="rect">
            <a:avLst/>
          </a:prstGeom>
        </p:spPr>
      </p:pic>
      <p:grpSp>
        <p:nvGrpSpPr>
          <p:cNvPr id="41" name="组合 40">
            <a:extLst>
              <a:ext uri="{FF2B5EF4-FFF2-40B4-BE49-F238E27FC236}">
                <a16:creationId xmlns:a16="http://schemas.microsoft.com/office/drawing/2014/main" id="{6DD1C5FD-17CB-B994-B533-D88A93269FDF}"/>
              </a:ext>
            </a:extLst>
          </p:cNvPr>
          <p:cNvGrpSpPr/>
          <p:nvPr/>
        </p:nvGrpSpPr>
        <p:grpSpPr>
          <a:xfrm>
            <a:off x="127731" y="696366"/>
            <a:ext cx="3054570" cy="1711637"/>
            <a:chOff x="445682" y="689029"/>
            <a:chExt cx="3054570" cy="1711637"/>
          </a:xfrm>
        </p:grpSpPr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26BDF3AD-0C18-C763-3120-18629BC67FCF}"/>
                </a:ext>
              </a:extLst>
            </p:cNvPr>
            <p:cNvGrpSpPr/>
            <p:nvPr/>
          </p:nvGrpSpPr>
          <p:grpSpPr>
            <a:xfrm>
              <a:off x="2276852" y="871138"/>
              <a:ext cx="1128026" cy="1066178"/>
              <a:chOff x="4412160" y="192177"/>
              <a:chExt cx="1128026" cy="1066178"/>
            </a:xfrm>
          </p:grpSpPr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FF8196C2-B24A-0D1C-3827-6B5AC80576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11558" t="53126" r="48438" b="35045"/>
              <a:stretch/>
            </p:blipFill>
            <p:spPr>
              <a:xfrm>
                <a:off x="4412160" y="1005942"/>
                <a:ext cx="1128026" cy="252413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D6D946F9-03B6-70B3-346D-37B821A1FD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l="31255" t="27806" r="14177" b="60205"/>
              <a:stretch/>
            </p:blipFill>
            <p:spPr>
              <a:xfrm>
                <a:off x="4412160" y="734687"/>
                <a:ext cx="1128026" cy="252413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84FA98A0-58C1-21AC-1040-09B66DD745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l="8824" t="31395" r="41424" b="56881"/>
              <a:stretch/>
            </p:blipFill>
            <p:spPr>
              <a:xfrm>
                <a:off x="4412160" y="463431"/>
                <a:ext cx="1128026" cy="252413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8AABC8FF-D840-30DE-23A6-563D124CF3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12043" t="35552" r="18333" b="51213"/>
              <a:stretch/>
            </p:blipFill>
            <p:spPr>
              <a:xfrm>
                <a:off x="4412160" y="192177"/>
                <a:ext cx="1128026" cy="252413"/>
              </a:xfrm>
              <a:prstGeom prst="rect">
                <a:avLst/>
              </a:prstGeom>
            </p:spPr>
          </p:pic>
        </p:grpSp>
        <p:grpSp>
          <p:nvGrpSpPr>
            <p:cNvPr id="23" name="组合 22"/>
            <p:cNvGrpSpPr/>
            <p:nvPr/>
          </p:nvGrpSpPr>
          <p:grpSpPr>
            <a:xfrm>
              <a:off x="445682" y="689029"/>
              <a:ext cx="3054570" cy="1711637"/>
              <a:chOff x="161314" y="49217"/>
              <a:chExt cx="3054570" cy="1711637"/>
            </a:xfrm>
          </p:grpSpPr>
          <p:sp>
            <p:nvSpPr>
              <p:cNvPr id="3" name="矩形 2"/>
              <p:cNvSpPr/>
              <p:nvPr/>
            </p:nvSpPr>
            <p:spPr>
              <a:xfrm>
                <a:off x="403368" y="245199"/>
                <a:ext cx="4892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矩形 4"/>
              <p:cNvSpPr/>
              <p:nvPr/>
            </p:nvSpPr>
            <p:spPr>
              <a:xfrm>
                <a:off x="1214721" y="49217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161314" y="519326"/>
                <a:ext cx="73129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l-GR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-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 III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矩形 6"/>
              <p:cNvSpPr/>
              <p:nvPr/>
            </p:nvSpPr>
            <p:spPr>
              <a:xfrm>
                <a:off x="415390" y="787709"/>
                <a:ext cx="4651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FAP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342453" y="1081419"/>
                <a:ext cx="55015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>
                <a:off x="2365014" y="50334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2 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矩形 1"/>
              <p:cNvSpPr/>
              <p:nvPr/>
            </p:nvSpPr>
            <p:spPr>
              <a:xfrm rot="18900000">
                <a:off x="656532" y="1361346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矩形 9"/>
              <p:cNvSpPr/>
              <p:nvPr/>
            </p:nvSpPr>
            <p:spPr>
              <a:xfrm rot="18900000">
                <a:off x="889183" y="1379371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 rot="18900000">
                <a:off x="804338" y="1520046"/>
                <a:ext cx="99097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Vector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 rot="18900000">
                <a:off x="1073821" y="1545410"/>
                <a:ext cx="99738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矩形 42"/>
              <p:cNvSpPr/>
              <p:nvPr/>
            </p:nvSpPr>
            <p:spPr>
              <a:xfrm rot="18900000">
                <a:off x="1819873" y="1361344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矩形 43"/>
              <p:cNvSpPr/>
              <p:nvPr/>
            </p:nvSpPr>
            <p:spPr>
              <a:xfrm rot="18900000">
                <a:off x="2021179" y="1379370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矩形 44"/>
              <p:cNvSpPr/>
              <p:nvPr/>
            </p:nvSpPr>
            <p:spPr>
              <a:xfrm rot="18900000">
                <a:off x="1923530" y="1529100"/>
                <a:ext cx="99097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Vector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矩形 45"/>
              <p:cNvSpPr/>
              <p:nvPr/>
            </p:nvSpPr>
            <p:spPr>
              <a:xfrm rot="18900000">
                <a:off x="2218495" y="1531366"/>
                <a:ext cx="99738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B9A0EC20-58FC-285B-BAA3-1C707143895C}"/>
                </a:ext>
              </a:extLst>
            </p:cNvPr>
            <p:cNvGrpSpPr/>
            <p:nvPr/>
          </p:nvGrpSpPr>
          <p:grpSpPr>
            <a:xfrm>
              <a:off x="1128398" y="871138"/>
              <a:ext cx="1128316" cy="1066178"/>
              <a:chOff x="3167576" y="192177"/>
              <a:chExt cx="1128316" cy="1066178"/>
            </a:xfrm>
          </p:grpSpPr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3657FAFD-D7F8-15FB-9AEC-875CA733D9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10418" t="62527" r="35264" b="25801"/>
              <a:stretch/>
            </p:blipFill>
            <p:spPr>
              <a:xfrm>
                <a:off x="3167576" y="1005942"/>
                <a:ext cx="1128026" cy="252413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42415D65-F8F9-453D-EE49-9F4D0E6EAB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rcRect l="31236" t="29994" r="10494" b="58334"/>
              <a:stretch/>
            </p:blipFill>
            <p:spPr>
              <a:xfrm>
                <a:off x="3167576" y="734687"/>
                <a:ext cx="1128026" cy="252413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27051D9F-8FA8-5375-1C16-4160992702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rcRect l="9086" t="25346" r="41532" b="62825"/>
              <a:stretch/>
            </p:blipFill>
            <p:spPr>
              <a:xfrm>
                <a:off x="3167576" y="463432"/>
                <a:ext cx="1128026" cy="252413"/>
              </a:xfrm>
              <a:prstGeom prst="rect">
                <a:avLst/>
              </a:prstGeom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B9ADCB7D-25B4-84C9-9D0F-DF8B33E0F0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13364" t="53959" r="25912" b="34861"/>
              <a:stretch/>
            </p:blipFill>
            <p:spPr>
              <a:xfrm>
                <a:off x="3167866" y="192177"/>
                <a:ext cx="1128026" cy="252413"/>
              </a:xfrm>
              <a:prstGeom prst="rect">
                <a:avLst/>
              </a:prstGeom>
            </p:spPr>
          </p:pic>
        </p:grpSp>
      </p:grpSp>
      <p:sp>
        <p:nvSpPr>
          <p:cNvPr id="13" name="矩形 12">
            <a:extLst>
              <a:ext uri="{FF2B5EF4-FFF2-40B4-BE49-F238E27FC236}">
                <a16:creationId xmlns:a16="http://schemas.microsoft.com/office/drawing/2014/main" id="{590478EA-A07F-211F-8D8B-24F862CB9C82}"/>
              </a:ext>
            </a:extLst>
          </p:cNvPr>
          <p:cNvSpPr/>
          <p:nvPr/>
        </p:nvSpPr>
        <p:spPr>
          <a:xfrm>
            <a:off x="-768252" y="2907108"/>
            <a:ext cx="74892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872B5A93-EC56-30EB-E7F9-6EBC1D7C766B}"/>
              </a:ext>
            </a:extLst>
          </p:cNvPr>
          <p:cNvSpPr/>
          <p:nvPr/>
        </p:nvSpPr>
        <p:spPr>
          <a:xfrm>
            <a:off x="-865534" y="5761610"/>
            <a:ext cx="74892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2828AD9A-B3DA-904B-652B-F7419C6C4978}"/>
              </a:ext>
            </a:extLst>
          </p:cNvPr>
          <p:cNvSpPr/>
          <p:nvPr/>
        </p:nvSpPr>
        <p:spPr>
          <a:xfrm>
            <a:off x="1356138" y="2915974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FD4CD1F-A786-18AE-B2BE-956F2DA961E0}"/>
              </a:ext>
            </a:extLst>
          </p:cNvPr>
          <p:cNvSpPr/>
          <p:nvPr/>
        </p:nvSpPr>
        <p:spPr>
          <a:xfrm>
            <a:off x="3815366" y="2996933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5147851C-9F4A-4528-3648-B45885C6C26E}"/>
              </a:ext>
            </a:extLst>
          </p:cNvPr>
          <p:cNvSpPr/>
          <p:nvPr/>
        </p:nvSpPr>
        <p:spPr>
          <a:xfrm>
            <a:off x="5925910" y="3014122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776A9042-3284-B342-0649-14605D328EC7}"/>
              </a:ext>
            </a:extLst>
          </p:cNvPr>
          <p:cNvSpPr/>
          <p:nvPr/>
        </p:nvSpPr>
        <p:spPr>
          <a:xfrm>
            <a:off x="1179630" y="5661228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254DC0A4-7489-7890-A4FE-AF58993DB559}"/>
              </a:ext>
            </a:extLst>
          </p:cNvPr>
          <p:cNvSpPr/>
          <p:nvPr/>
        </p:nvSpPr>
        <p:spPr>
          <a:xfrm>
            <a:off x="3603036" y="5726835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1A320192-A55C-1BED-6D66-0E22FD1AF3CA}"/>
              </a:ext>
            </a:extLst>
          </p:cNvPr>
          <p:cNvSpPr/>
          <p:nvPr/>
        </p:nvSpPr>
        <p:spPr>
          <a:xfrm>
            <a:off x="5856692" y="5724619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FB623F0-BEB1-38EB-3D48-FCFC692F06D6}"/>
              </a:ext>
            </a:extLst>
          </p:cNvPr>
          <p:cNvSpPr txBox="1"/>
          <p:nvPr/>
        </p:nvSpPr>
        <p:spPr>
          <a:xfrm>
            <a:off x="104245" y="73171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4A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531808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B14332-ADEA-6916-A2EA-C09605F386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0CBB3890-6370-3CAC-ED0D-0D440DE126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419" y="2765564"/>
            <a:ext cx="1676634" cy="2286319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03F908F-28D8-FF25-BC0F-407917EA63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3555" y="5472639"/>
            <a:ext cx="2896004" cy="222916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792A5CF-7D87-C72F-52E6-9673F77D41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3555" y="2765564"/>
            <a:ext cx="1638529" cy="236253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6CF3282-30AA-1E82-F75C-FD578A7F0D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5780" y="5472639"/>
            <a:ext cx="1895740" cy="2410161"/>
          </a:xfrm>
          <a:prstGeom prst="rect">
            <a:avLst/>
          </a:prstGeom>
        </p:spPr>
      </p:pic>
      <p:grpSp>
        <p:nvGrpSpPr>
          <p:cNvPr id="11" name="组合 10">
            <a:extLst>
              <a:ext uri="{FF2B5EF4-FFF2-40B4-BE49-F238E27FC236}">
                <a16:creationId xmlns:a16="http://schemas.microsoft.com/office/drawing/2014/main" id="{7F6AD7B7-4F2A-B818-C06A-0EF2CE2E82E2}"/>
              </a:ext>
            </a:extLst>
          </p:cNvPr>
          <p:cNvGrpSpPr/>
          <p:nvPr/>
        </p:nvGrpSpPr>
        <p:grpSpPr>
          <a:xfrm>
            <a:off x="190116" y="628024"/>
            <a:ext cx="1928356" cy="1699714"/>
            <a:chOff x="487348" y="-63000"/>
            <a:chExt cx="1928356" cy="1699714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668886CA-48F5-C4B5-C065-BBD6728B53F8}"/>
                </a:ext>
              </a:extLst>
            </p:cNvPr>
            <p:cNvGrpSpPr/>
            <p:nvPr/>
          </p:nvGrpSpPr>
          <p:grpSpPr>
            <a:xfrm>
              <a:off x="487348" y="-63000"/>
              <a:ext cx="1928356" cy="1699714"/>
              <a:chOff x="367303" y="6399266"/>
              <a:chExt cx="1928356" cy="1699714"/>
            </a:xfrm>
          </p:grpSpPr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100A455E-75C2-D9EB-1008-F783CA187A96}"/>
                  </a:ext>
                </a:extLst>
              </p:cNvPr>
              <p:cNvSpPr/>
              <p:nvPr/>
            </p:nvSpPr>
            <p:spPr>
              <a:xfrm>
                <a:off x="536829" y="7412969"/>
                <a:ext cx="55015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CB187E5F-1154-49DB-56EB-75BABEAE61AF}"/>
                  </a:ext>
                </a:extLst>
              </p:cNvPr>
              <p:cNvSpPr/>
              <p:nvPr/>
            </p:nvSpPr>
            <p:spPr>
              <a:xfrm>
                <a:off x="609357" y="6608081"/>
                <a:ext cx="4892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8DC2624D-4E31-EAAC-3FF9-9A62E3F6358D}"/>
                  </a:ext>
                </a:extLst>
              </p:cNvPr>
              <p:cNvSpPr/>
              <p:nvPr/>
            </p:nvSpPr>
            <p:spPr>
              <a:xfrm>
                <a:off x="367303" y="6873868"/>
                <a:ext cx="73129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altLang="zh-CN" sz="800">
                    <a:latin typeface="Arial" panose="020B0604020202020204" pitchFamily="34" charset="0"/>
                    <a:cs typeface="Arial" panose="020B0604020202020204" pitchFamily="34" charset="0"/>
                  </a:rPr>
                  <a:t>β-</a:t>
                </a:r>
                <a:r>
                  <a:rPr lang="en-US" altLang="zh-CN" sz="800">
                    <a:latin typeface="Arial" panose="020B0604020202020204" pitchFamily="34" charset="0"/>
                    <a:cs typeface="Arial" panose="020B0604020202020204" pitchFamily="34" charset="0"/>
                  </a:rPr>
                  <a:t>Tubulin III</a:t>
                </a:r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6E10E9E6-DE1E-19CB-74F3-CCD7E724B247}"/>
                  </a:ext>
                </a:extLst>
              </p:cNvPr>
              <p:cNvSpPr/>
              <p:nvPr/>
            </p:nvSpPr>
            <p:spPr>
              <a:xfrm>
                <a:off x="621788" y="7141928"/>
                <a:ext cx="4651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FAP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03A5F11D-5C2C-0251-708C-F7358AB4752C}"/>
                  </a:ext>
                </a:extLst>
              </p:cNvPr>
              <p:cNvSpPr/>
              <p:nvPr/>
            </p:nvSpPr>
            <p:spPr>
              <a:xfrm>
                <a:off x="1447764" y="6399266"/>
                <a:ext cx="38664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8 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B670ECE8-C5AD-E839-0622-D7BDE740EBC2}"/>
                  </a:ext>
                </a:extLst>
              </p:cNvPr>
              <p:cNvSpPr/>
              <p:nvPr/>
            </p:nvSpPr>
            <p:spPr>
              <a:xfrm rot="18900000">
                <a:off x="880575" y="7693101"/>
                <a:ext cx="51648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371CBE71-5847-70B3-2A69-B49690111F28}"/>
                  </a:ext>
                </a:extLst>
              </p:cNvPr>
              <p:cNvSpPr/>
              <p:nvPr/>
            </p:nvSpPr>
            <p:spPr>
              <a:xfrm rot="18900000">
                <a:off x="1103301" y="7714071"/>
                <a:ext cx="57579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9919FF75-B305-FF3A-73E8-DD9F48E95A99}"/>
                  </a:ext>
                </a:extLst>
              </p:cNvPr>
              <p:cNvSpPr/>
              <p:nvPr/>
            </p:nvSpPr>
            <p:spPr>
              <a:xfrm rot="18900000">
                <a:off x="994988" y="7860859"/>
                <a:ext cx="99097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Vector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83BDA083-548C-5CD8-5E22-BEF45E9DD9A0}"/>
                  </a:ext>
                </a:extLst>
              </p:cNvPr>
              <p:cNvSpPr/>
              <p:nvPr/>
            </p:nvSpPr>
            <p:spPr>
              <a:xfrm rot="18900000">
                <a:off x="1298270" y="7883536"/>
                <a:ext cx="99738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o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×3 + 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A7F6A541-BC7F-BAE1-5B28-EEA9051FA447}"/>
                </a:ext>
              </a:extLst>
            </p:cNvPr>
            <p:cNvGrpSpPr/>
            <p:nvPr/>
          </p:nvGrpSpPr>
          <p:grpSpPr>
            <a:xfrm>
              <a:off x="1176451" y="130419"/>
              <a:ext cx="1169360" cy="1051832"/>
              <a:chOff x="1681790" y="2751040"/>
              <a:chExt cx="1169360" cy="1051832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E8312F25-0047-6D1D-A47B-C01B32C8F5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14317" t="27846" r="22755" b="61671"/>
              <a:stretch/>
            </p:blipFill>
            <p:spPr>
              <a:xfrm>
                <a:off x="1681790" y="3287161"/>
                <a:ext cx="1169360" cy="247651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224F3A91-42E3-AFA3-9D30-E5988C93F5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11585" t="26913" r="18669" b="62255"/>
              <a:stretch/>
            </p:blipFill>
            <p:spPr>
              <a:xfrm>
                <a:off x="1681790" y="2751040"/>
                <a:ext cx="1169360" cy="247652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3C57C6CE-0421-9E5F-CB13-E61BA830CF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9265" t="52283" r="51218" b="36608"/>
              <a:stretch/>
            </p:blipFill>
            <p:spPr>
              <a:xfrm>
                <a:off x="1681790" y="3555221"/>
                <a:ext cx="1169360" cy="247651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952A1151-B2E9-DBBC-DB7C-C259FD1833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11020" t="32439" r="17614" b="57079"/>
              <a:stretch/>
            </p:blipFill>
            <p:spPr>
              <a:xfrm>
                <a:off x="1681790" y="3019101"/>
                <a:ext cx="1169360" cy="247651"/>
              </a:xfrm>
              <a:prstGeom prst="rect">
                <a:avLst/>
              </a:prstGeom>
            </p:spPr>
          </p:pic>
        </p:grp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2B75BE0A-3637-D09C-74D0-CB9C64CAB9C0}"/>
              </a:ext>
            </a:extLst>
          </p:cNvPr>
          <p:cNvSpPr/>
          <p:nvPr/>
        </p:nvSpPr>
        <p:spPr>
          <a:xfrm>
            <a:off x="3601933" y="5247467"/>
            <a:ext cx="55015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6B1DD4D6-0C66-8C5E-A902-1B6B96B0C733}"/>
              </a:ext>
            </a:extLst>
          </p:cNvPr>
          <p:cNvSpPr/>
          <p:nvPr/>
        </p:nvSpPr>
        <p:spPr>
          <a:xfrm>
            <a:off x="1199032" y="2550120"/>
            <a:ext cx="489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901F4A85-3F33-9524-3570-397E0DCF9188}"/>
              </a:ext>
            </a:extLst>
          </p:cNvPr>
          <p:cNvSpPr/>
          <p:nvPr/>
        </p:nvSpPr>
        <p:spPr>
          <a:xfrm>
            <a:off x="3044145" y="2550120"/>
            <a:ext cx="73129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21335FAA-7AD0-090E-2966-4F41B274DC02}"/>
              </a:ext>
            </a:extLst>
          </p:cNvPr>
          <p:cNvSpPr/>
          <p:nvPr/>
        </p:nvSpPr>
        <p:spPr>
          <a:xfrm>
            <a:off x="1236533" y="5247871"/>
            <a:ext cx="46519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B8B4C75-17A0-F8D7-AEA0-C8574D820589}"/>
              </a:ext>
            </a:extLst>
          </p:cNvPr>
          <p:cNvSpPr txBox="1"/>
          <p:nvPr/>
        </p:nvSpPr>
        <p:spPr>
          <a:xfrm>
            <a:off x="104245" y="73171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4C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918810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40">
            <a:extLst>
              <a:ext uri="{FF2B5EF4-FFF2-40B4-BE49-F238E27FC236}">
                <a16:creationId xmlns:a16="http://schemas.microsoft.com/office/drawing/2014/main" id="{C8886A2C-D2F8-D4D4-1FD7-9EE24FC5CD09}"/>
              </a:ext>
            </a:extLst>
          </p:cNvPr>
          <p:cNvGrpSpPr/>
          <p:nvPr/>
        </p:nvGrpSpPr>
        <p:grpSpPr>
          <a:xfrm>
            <a:off x="514249" y="956268"/>
            <a:ext cx="1582859" cy="1004772"/>
            <a:chOff x="773378" y="69304"/>
            <a:chExt cx="1582859" cy="1004772"/>
          </a:xfrm>
        </p:grpSpPr>
        <p:grpSp>
          <p:nvGrpSpPr>
            <p:cNvPr id="15" name="组合 14"/>
            <p:cNvGrpSpPr/>
            <p:nvPr/>
          </p:nvGrpSpPr>
          <p:grpSpPr>
            <a:xfrm>
              <a:off x="829234" y="69304"/>
              <a:ext cx="1527003" cy="982536"/>
              <a:chOff x="4922009" y="69303"/>
              <a:chExt cx="1527003" cy="982536"/>
            </a:xfrm>
          </p:grpSpPr>
          <p:sp>
            <p:nvSpPr>
              <p:cNvPr id="2" name="矩形 1"/>
              <p:cNvSpPr/>
              <p:nvPr/>
            </p:nvSpPr>
            <p:spPr>
              <a:xfrm>
                <a:off x="5687265" y="568063"/>
                <a:ext cx="76174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B:GRIN2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矩形 4"/>
              <p:cNvSpPr/>
              <p:nvPr/>
            </p:nvSpPr>
            <p:spPr>
              <a:xfrm>
                <a:off x="5702667" y="836395"/>
                <a:ext cx="68320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B: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矩形 6"/>
              <p:cNvSpPr/>
              <p:nvPr/>
            </p:nvSpPr>
            <p:spPr>
              <a:xfrm>
                <a:off x="5327598" y="69303"/>
                <a:ext cx="28245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P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 rot="16200000">
                <a:off x="4821982" y="289357"/>
                <a:ext cx="41549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 rot="16200000">
                <a:off x="5148526" y="315951"/>
                <a:ext cx="34496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gG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矩形 9"/>
              <p:cNvSpPr/>
              <p:nvPr/>
            </p:nvSpPr>
            <p:spPr>
              <a:xfrm rot="16200000">
                <a:off x="5387216" y="311274"/>
                <a:ext cx="38504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" name="直接连接符 13"/>
              <p:cNvCxnSpPr/>
              <p:nvPr/>
            </p:nvCxnSpPr>
            <p:spPr>
              <a:xfrm flipV="1">
                <a:off x="5230611" y="267496"/>
                <a:ext cx="47205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F00F924F-708C-E022-8511-909652090306}"/>
                </a:ext>
              </a:extLst>
            </p:cNvPr>
            <p:cNvGrpSpPr/>
            <p:nvPr/>
          </p:nvGrpSpPr>
          <p:grpSpPr>
            <a:xfrm>
              <a:off x="773378" y="545243"/>
              <a:ext cx="882674" cy="528833"/>
              <a:chOff x="3333674" y="305889"/>
              <a:chExt cx="882674" cy="528833"/>
            </a:xfrm>
          </p:grpSpPr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C8BB3653-8A57-2DA8-CFEF-C888F82AF0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13027" t="28212" r="35497" b="60874"/>
              <a:stretch/>
            </p:blipFill>
            <p:spPr>
              <a:xfrm>
                <a:off x="3333674" y="574807"/>
                <a:ext cx="882674" cy="259915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585E8367-3432-333F-389C-1984A9C8A9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10109" t="15316" r="39259" b="72169"/>
              <a:stretch/>
            </p:blipFill>
            <p:spPr>
              <a:xfrm>
                <a:off x="3333674" y="305889"/>
                <a:ext cx="882674" cy="259914"/>
              </a:xfrm>
              <a:prstGeom prst="rect">
                <a:avLst/>
              </a:prstGeom>
            </p:spPr>
          </p:pic>
        </p:grpSp>
      </p:grp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42605252-0C36-052B-D710-A2B58F8A4B2D}"/>
              </a:ext>
            </a:extLst>
          </p:cNvPr>
          <p:cNvGrpSpPr/>
          <p:nvPr/>
        </p:nvGrpSpPr>
        <p:grpSpPr>
          <a:xfrm>
            <a:off x="449974" y="3982793"/>
            <a:ext cx="1583989" cy="980397"/>
            <a:chOff x="861383" y="3323121"/>
            <a:chExt cx="1583989" cy="980397"/>
          </a:xfrm>
        </p:grpSpPr>
        <p:grpSp>
          <p:nvGrpSpPr>
            <p:cNvPr id="31" name="组合 30"/>
            <p:cNvGrpSpPr/>
            <p:nvPr/>
          </p:nvGrpSpPr>
          <p:grpSpPr>
            <a:xfrm>
              <a:off x="930988" y="3323121"/>
              <a:ext cx="1514384" cy="980397"/>
              <a:chOff x="4927579" y="99299"/>
              <a:chExt cx="1514384" cy="980397"/>
            </a:xfrm>
          </p:grpSpPr>
          <p:sp>
            <p:nvSpPr>
              <p:cNvPr id="32" name="矩形 31"/>
              <p:cNvSpPr/>
              <p:nvPr/>
            </p:nvSpPr>
            <p:spPr>
              <a:xfrm>
                <a:off x="5680216" y="582100"/>
                <a:ext cx="76174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B:GRIN2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矩形 32"/>
              <p:cNvSpPr/>
              <p:nvPr/>
            </p:nvSpPr>
            <p:spPr>
              <a:xfrm>
                <a:off x="5688954" y="864252"/>
                <a:ext cx="68320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B:KLF17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矩形 33"/>
              <p:cNvSpPr/>
              <p:nvPr/>
            </p:nvSpPr>
            <p:spPr>
              <a:xfrm>
                <a:off x="5319945" y="99299"/>
                <a:ext cx="28245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P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矩形 34"/>
              <p:cNvSpPr/>
              <p:nvPr/>
            </p:nvSpPr>
            <p:spPr>
              <a:xfrm rot="16200000">
                <a:off x="4827552" y="266629"/>
                <a:ext cx="41549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矩形 35"/>
              <p:cNvSpPr/>
              <p:nvPr/>
            </p:nvSpPr>
            <p:spPr>
              <a:xfrm rot="16200000">
                <a:off x="5121917" y="325380"/>
                <a:ext cx="34496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gG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矩形 36"/>
              <p:cNvSpPr/>
              <p:nvPr/>
            </p:nvSpPr>
            <p:spPr>
              <a:xfrm rot="16200000">
                <a:off x="5407026" y="325380"/>
                <a:ext cx="32733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直接连接符 39"/>
              <p:cNvCxnSpPr/>
              <p:nvPr/>
            </p:nvCxnSpPr>
            <p:spPr>
              <a:xfrm flipV="1">
                <a:off x="5206359" y="286183"/>
                <a:ext cx="47205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2BA6CA03-23AF-BE41-3A3B-6D7127C6906A}"/>
                </a:ext>
              </a:extLst>
            </p:cNvPr>
            <p:cNvGrpSpPr/>
            <p:nvPr/>
          </p:nvGrpSpPr>
          <p:grpSpPr>
            <a:xfrm>
              <a:off x="861383" y="3763443"/>
              <a:ext cx="882674" cy="540075"/>
              <a:chOff x="3208663" y="3900486"/>
              <a:chExt cx="882674" cy="540075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FE50073F-FFD0-F12F-354A-9207F26554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15454" t="25447" r="16914" b="62263"/>
              <a:stretch/>
            </p:blipFill>
            <p:spPr>
              <a:xfrm>
                <a:off x="3208663" y="4180645"/>
                <a:ext cx="882674" cy="259916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30ECEA02-1844-9971-4CE7-6307B992BE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17584" t="18066" r="18953" b="69808"/>
              <a:stretch/>
            </p:blipFill>
            <p:spPr>
              <a:xfrm>
                <a:off x="3208663" y="3900486"/>
                <a:ext cx="882674" cy="259915"/>
              </a:xfrm>
              <a:prstGeom prst="rect">
                <a:avLst/>
              </a:prstGeom>
            </p:spPr>
          </p:pic>
        </p:grpSp>
      </p:grpSp>
      <p:pic>
        <p:nvPicPr>
          <p:cNvPr id="22" name="图片 21">
            <a:extLst>
              <a:ext uri="{FF2B5EF4-FFF2-40B4-BE49-F238E27FC236}">
                <a16:creationId xmlns:a16="http://schemas.microsoft.com/office/drawing/2014/main" id="{A3B2AAD4-1067-F51E-B544-6F90C6F9CC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57296" y="3968745"/>
            <a:ext cx="1305107" cy="211484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0034A6E4-CB00-47B7-7E78-1781349A3D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4554" y="973413"/>
            <a:ext cx="1714739" cy="2381582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5613075-D6A9-9C1E-1317-CFA6849E48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1065" y="956268"/>
            <a:ext cx="1743318" cy="207674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BD8A488-028D-2EB1-DBD3-B8AD1F78A5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75973" y="3891478"/>
            <a:ext cx="1390844" cy="2143424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110750D7-7E71-4AFC-7845-1C31FBE0902D}"/>
              </a:ext>
            </a:extLst>
          </p:cNvPr>
          <p:cNvSpPr/>
          <p:nvPr/>
        </p:nvSpPr>
        <p:spPr>
          <a:xfrm>
            <a:off x="2826050" y="735140"/>
            <a:ext cx="56778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CB8E224C-A1C6-A3A8-1741-58EEE7A8FD06}"/>
              </a:ext>
            </a:extLst>
          </p:cNvPr>
          <p:cNvSpPr/>
          <p:nvPr/>
        </p:nvSpPr>
        <p:spPr>
          <a:xfrm>
            <a:off x="4963603" y="748241"/>
            <a:ext cx="489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E02E8815-DAB3-30B7-2114-431DC313E895}"/>
              </a:ext>
            </a:extLst>
          </p:cNvPr>
          <p:cNvSpPr/>
          <p:nvPr/>
        </p:nvSpPr>
        <p:spPr>
          <a:xfrm>
            <a:off x="2909856" y="3666306"/>
            <a:ext cx="56778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4154FBAB-9D99-5ED4-71D7-1BA1E9B488B9}"/>
              </a:ext>
            </a:extLst>
          </p:cNvPr>
          <p:cNvSpPr/>
          <p:nvPr/>
        </p:nvSpPr>
        <p:spPr>
          <a:xfrm>
            <a:off x="4920951" y="3747502"/>
            <a:ext cx="489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1685556-06B7-66FA-2732-F58742E6E9B2}"/>
              </a:ext>
            </a:extLst>
          </p:cNvPr>
          <p:cNvSpPr txBox="1"/>
          <p:nvPr/>
        </p:nvSpPr>
        <p:spPr>
          <a:xfrm>
            <a:off x="71055" y="77826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5B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234409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AA03BCC9-4200-728E-C30E-E38F2339CB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3753328" y="3396873"/>
            <a:ext cx="2444385" cy="2524477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5C3CA518-3A2B-DBD6-60C2-1602A0772A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3989661" y="6485648"/>
            <a:ext cx="1971718" cy="2486372"/>
          </a:xfrm>
          <a:prstGeom prst="rect">
            <a:avLst/>
          </a:prstGeom>
        </p:spPr>
      </p:pic>
      <p:pic>
        <p:nvPicPr>
          <p:cNvPr id="150" name="图片 149">
            <a:extLst>
              <a:ext uri="{FF2B5EF4-FFF2-40B4-BE49-F238E27FC236}">
                <a16:creationId xmlns:a16="http://schemas.microsoft.com/office/drawing/2014/main" id="{AACCC3F2-99FB-2BEB-4DBF-64589ECBD0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2996878" y="3425452"/>
            <a:ext cx="2086266" cy="2495898"/>
          </a:xfrm>
          <a:prstGeom prst="rect">
            <a:avLst/>
          </a:prstGeom>
        </p:spPr>
      </p:pic>
      <p:pic>
        <p:nvPicPr>
          <p:cNvPr id="152" name="图片 151">
            <a:extLst>
              <a:ext uri="{FF2B5EF4-FFF2-40B4-BE49-F238E27FC236}">
                <a16:creationId xmlns:a16="http://schemas.microsoft.com/office/drawing/2014/main" id="{4DFE9C9A-5AC4-1AA6-EA63-4CE2EE69AB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704847" y="3431250"/>
            <a:ext cx="1811945" cy="2490100"/>
          </a:xfrm>
          <a:prstGeom prst="rect">
            <a:avLst/>
          </a:prstGeom>
        </p:spPr>
      </p:pic>
      <p:pic>
        <p:nvPicPr>
          <p:cNvPr id="154" name="图片 153">
            <a:extLst>
              <a:ext uri="{FF2B5EF4-FFF2-40B4-BE49-F238E27FC236}">
                <a16:creationId xmlns:a16="http://schemas.microsoft.com/office/drawing/2014/main" id="{1C6BDB6E-F25C-192C-ED18-91B62BA072B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726177" y="6544425"/>
            <a:ext cx="1854603" cy="2347734"/>
          </a:xfrm>
          <a:prstGeom prst="rect">
            <a:avLst/>
          </a:prstGeom>
        </p:spPr>
      </p:pic>
      <p:pic>
        <p:nvPicPr>
          <p:cNvPr id="156" name="图片 155">
            <a:extLst>
              <a:ext uri="{FF2B5EF4-FFF2-40B4-BE49-F238E27FC236}">
                <a16:creationId xmlns:a16="http://schemas.microsoft.com/office/drawing/2014/main" id="{8E78E565-DC4C-7A74-6D9F-A73E83EA36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82085" y="3425452"/>
            <a:ext cx="3028638" cy="2334575"/>
          </a:xfrm>
          <a:prstGeom prst="rect">
            <a:avLst/>
          </a:prstGeom>
        </p:spPr>
      </p:pic>
      <p:pic>
        <p:nvPicPr>
          <p:cNvPr id="158" name="图片 157">
            <a:extLst>
              <a:ext uri="{FF2B5EF4-FFF2-40B4-BE49-F238E27FC236}">
                <a16:creationId xmlns:a16="http://schemas.microsoft.com/office/drawing/2014/main" id="{C803A3FE-3C15-7984-444F-C42AC32B3B9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428982" y="6680432"/>
            <a:ext cx="2981741" cy="215295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4DCB6AEA-ACBD-393E-362E-A858F4B0B6C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1593992" y="3378756"/>
            <a:ext cx="1916092" cy="238127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C668D854-0727-F597-A37B-D9345128FB8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1624737" y="6349366"/>
            <a:ext cx="1854603" cy="2583197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CF0498E-F8B5-DBC8-8407-F21CA5A48F5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-2782536" y="6485648"/>
            <a:ext cx="1657581" cy="2229161"/>
          </a:xfrm>
          <a:prstGeom prst="rect">
            <a:avLst/>
          </a:prstGeom>
        </p:spPr>
      </p:pic>
      <p:grpSp>
        <p:nvGrpSpPr>
          <p:cNvPr id="36" name="组合 35">
            <a:extLst>
              <a:ext uri="{FF2B5EF4-FFF2-40B4-BE49-F238E27FC236}">
                <a16:creationId xmlns:a16="http://schemas.microsoft.com/office/drawing/2014/main" id="{57008016-A4ED-5417-0A80-FD720F330E5C}"/>
              </a:ext>
            </a:extLst>
          </p:cNvPr>
          <p:cNvGrpSpPr/>
          <p:nvPr/>
        </p:nvGrpSpPr>
        <p:grpSpPr>
          <a:xfrm>
            <a:off x="108444" y="569572"/>
            <a:ext cx="3153244" cy="2006776"/>
            <a:chOff x="1764" y="130978"/>
            <a:chExt cx="3153244" cy="2006776"/>
          </a:xfrm>
        </p:grpSpPr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7900C29B-D253-CC30-4253-FB1C2172D65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10607" t="52792" r="48089" b="36926"/>
            <a:stretch/>
          </p:blipFill>
          <p:spPr>
            <a:xfrm>
              <a:off x="690722" y="1271667"/>
              <a:ext cx="1122758" cy="215444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41A6D5B7-CFE2-C2A6-800A-A9A5B082C6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0777" t="19595" r="37478" b="69356"/>
            <a:stretch/>
          </p:blipFill>
          <p:spPr>
            <a:xfrm flipH="1">
              <a:off x="690722" y="1023779"/>
              <a:ext cx="1122758" cy="241530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B9616175-3A2F-55A5-A0C1-AA189E22DA9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l="14804" t="39074" r="13668" b="51879"/>
            <a:stretch/>
          </p:blipFill>
          <p:spPr>
            <a:xfrm>
              <a:off x="696807" y="798104"/>
              <a:ext cx="1122758" cy="215444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6C9EF443-FC0E-F0E6-6A72-C235EE8E685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6462" t="35078" r="13287" b="55222"/>
            <a:stretch/>
          </p:blipFill>
          <p:spPr>
            <a:xfrm>
              <a:off x="696807" y="544078"/>
              <a:ext cx="1122758" cy="241529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>
              <a:off x="1764" y="326138"/>
              <a:ext cx="7312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l-GR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ubulin III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>
              <a:off x="276246" y="552688"/>
              <a:ext cx="46519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>
              <a:off x="185230" y="1278025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2217920" y="130978"/>
              <a:ext cx="3866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72 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8900000">
              <a:off x="482557" y="1554271"/>
              <a:ext cx="51648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8900000">
              <a:off x="77265" y="1831790"/>
              <a:ext cx="131157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vo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×3 + vector + 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8900000">
              <a:off x="553770" y="1744659"/>
              <a:ext cx="107593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vo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×3 + GRIN2B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8900000">
              <a:off x="415862" y="1919783"/>
              <a:ext cx="157126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vo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×3 + GRIN2B + siKLF1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>
              <a:off x="1035368" y="131819"/>
              <a:ext cx="3866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 rot="18900000">
              <a:off x="1676161" y="1546627"/>
              <a:ext cx="51648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/>
            <p:cNvSpPr/>
            <p:nvPr/>
          </p:nvSpPr>
          <p:spPr>
            <a:xfrm rot="18900000">
              <a:off x="1260300" y="1830495"/>
              <a:ext cx="131157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vo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×3 + vector + 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/>
            <p:cNvSpPr/>
            <p:nvPr/>
          </p:nvSpPr>
          <p:spPr>
            <a:xfrm rot="18900000">
              <a:off x="1733896" y="1747184"/>
              <a:ext cx="107593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vo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×3 + GRIN2B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矩形 40"/>
            <p:cNvSpPr/>
            <p:nvPr/>
          </p:nvSpPr>
          <p:spPr>
            <a:xfrm rot="18900000">
              <a:off x="1583744" y="1922310"/>
              <a:ext cx="157126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vo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×3 + GRIN2B + siKLF1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9D0DBC02-09D3-1353-6383-0A09E6A15D3E}"/>
                </a:ext>
              </a:extLst>
            </p:cNvPr>
            <p:cNvSpPr/>
            <p:nvPr/>
          </p:nvSpPr>
          <p:spPr>
            <a:xfrm>
              <a:off x="165270" y="782336"/>
              <a:ext cx="5677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RIN2B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E1D86871-F054-4672-C3B1-07C6B6F04D24}"/>
                </a:ext>
              </a:extLst>
            </p:cNvPr>
            <p:cNvSpPr/>
            <p:nvPr/>
          </p:nvSpPr>
          <p:spPr>
            <a:xfrm>
              <a:off x="252202" y="1033956"/>
              <a:ext cx="4892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KLF1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0184C9AF-891F-4AA5-FDB2-8D321B3E5D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7069" t="22182" r="17542" b="68104"/>
            <a:stretch/>
          </p:blipFill>
          <p:spPr>
            <a:xfrm flipH="1">
              <a:off x="1852901" y="1018180"/>
              <a:ext cx="1116682" cy="241529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DFA4F973-5875-B679-4CB9-7480642B084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1240" t="42392" r="24944" b="45390"/>
            <a:stretch/>
          </p:blipFill>
          <p:spPr>
            <a:xfrm>
              <a:off x="690722" y="322005"/>
              <a:ext cx="1122758" cy="209346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F4749E35-8B04-C085-AF8A-1999511D9D8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18638" t="31681" r="11717" b="56760"/>
            <a:stretch/>
          </p:blipFill>
          <p:spPr>
            <a:xfrm>
              <a:off x="1852902" y="539569"/>
              <a:ext cx="1116682" cy="241529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706BEF76-4D5F-256F-65D9-5E3771B3450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10091" t="50357" r="51278" b="39320"/>
            <a:stretch/>
          </p:blipFill>
          <p:spPr>
            <a:xfrm>
              <a:off x="1852901" y="1271668"/>
              <a:ext cx="1116683" cy="215444"/>
            </a:xfrm>
            <a:prstGeom prst="rect">
              <a:avLst/>
            </a:prstGeom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669287FD-14A8-5C8B-28EE-96778D7284A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rcRect l="12732" t="39055" r="15757" b="51110"/>
            <a:stretch/>
          </p:blipFill>
          <p:spPr>
            <a:xfrm>
              <a:off x="1852902" y="797070"/>
              <a:ext cx="1124754" cy="215444"/>
            </a:xfrm>
            <a:prstGeom prst="rect">
              <a:avLst/>
            </a:prstGeom>
          </p:spPr>
        </p:pic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65094A7F-A2B4-C104-8439-B065B7C59EF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l="16707" t="35615" r="15558" b="54720"/>
            <a:stretch/>
          </p:blipFill>
          <p:spPr>
            <a:xfrm>
              <a:off x="1849863" y="312166"/>
              <a:ext cx="1122758" cy="215444"/>
            </a:xfrm>
            <a:prstGeom prst="rect">
              <a:avLst/>
            </a:prstGeom>
          </p:spPr>
        </p:pic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33711A98-68E9-021D-12CE-7433824372D8}"/>
              </a:ext>
            </a:extLst>
          </p:cNvPr>
          <p:cNvSpPr/>
          <p:nvPr/>
        </p:nvSpPr>
        <p:spPr>
          <a:xfrm>
            <a:off x="2191465" y="3124815"/>
            <a:ext cx="82747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1ABE8E33-CDC0-28AB-618A-C490F1851B8D}"/>
              </a:ext>
            </a:extLst>
          </p:cNvPr>
          <p:cNvSpPr/>
          <p:nvPr/>
        </p:nvSpPr>
        <p:spPr>
          <a:xfrm>
            <a:off x="-2366381" y="3182768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1E2240FF-3239-03C7-9AF3-F8C210C332AC}"/>
              </a:ext>
            </a:extLst>
          </p:cNvPr>
          <p:cNvSpPr/>
          <p:nvPr/>
        </p:nvSpPr>
        <p:spPr>
          <a:xfrm>
            <a:off x="-91562" y="3224825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C261FCCE-99B1-3977-A1D1-4A1868359316}"/>
              </a:ext>
            </a:extLst>
          </p:cNvPr>
          <p:cNvSpPr/>
          <p:nvPr/>
        </p:nvSpPr>
        <p:spPr>
          <a:xfrm>
            <a:off x="7636782" y="3181429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6D2B426E-82B9-CD5D-46B3-AA59F1159EC3}"/>
              </a:ext>
            </a:extLst>
          </p:cNvPr>
          <p:cNvSpPr/>
          <p:nvPr/>
        </p:nvSpPr>
        <p:spPr>
          <a:xfrm>
            <a:off x="-2356260" y="6266329"/>
            <a:ext cx="990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 III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CACC766E-C96C-8F41-AF9E-D29893D51794}"/>
              </a:ext>
            </a:extLst>
          </p:cNvPr>
          <p:cNvSpPr/>
          <p:nvPr/>
        </p:nvSpPr>
        <p:spPr>
          <a:xfrm>
            <a:off x="-3557" y="6335671"/>
            <a:ext cx="7248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FA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72B552D8-7C39-21A5-6EA8-25ED992C043D}"/>
              </a:ext>
            </a:extLst>
          </p:cNvPr>
          <p:cNvSpPr/>
          <p:nvPr/>
        </p:nvSpPr>
        <p:spPr>
          <a:xfrm>
            <a:off x="7636782" y="6464988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6AA656E8-02CF-40E5-5801-BE1D3850B02F}"/>
              </a:ext>
            </a:extLst>
          </p:cNvPr>
          <p:cNvSpPr/>
          <p:nvPr/>
        </p:nvSpPr>
        <p:spPr>
          <a:xfrm>
            <a:off x="2138302" y="6133922"/>
            <a:ext cx="8274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GRIN2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3E6D22B8-B834-1AB7-2817-A3B852C0994D}"/>
              </a:ext>
            </a:extLst>
          </p:cNvPr>
          <p:cNvSpPr/>
          <p:nvPr/>
        </p:nvSpPr>
        <p:spPr>
          <a:xfrm>
            <a:off x="4699320" y="3124815"/>
            <a:ext cx="74892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4 h, 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17B1FB14-950C-207F-3B7F-3F02CB7F938D}"/>
              </a:ext>
            </a:extLst>
          </p:cNvPr>
          <p:cNvSpPr/>
          <p:nvPr/>
        </p:nvSpPr>
        <p:spPr>
          <a:xfrm>
            <a:off x="4699320" y="6260243"/>
            <a:ext cx="74892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 h, KLF1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0240E239-107C-C670-44D6-2AA3415BC153}"/>
              </a:ext>
            </a:extLst>
          </p:cNvPr>
          <p:cNvSpPr txBox="1"/>
          <p:nvPr/>
        </p:nvSpPr>
        <p:spPr>
          <a:xfrm>
            <a:off x="71055" y="38637"/>
            <a:ext cx="509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Uncropped images of western blotting in Figure </a:t>
            </a:r>
            <a:r>
              <a:rPr lang="en-US" altLang="zh-CN" dirty="0"/>
              <a:t>6A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83472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5</TotalTime>
  <Words>500</Words>
  <PresentationFormat>A4 纸张(210x297 毫米)</PresentationFormat>
  <Paragraphs>156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6-04T09:23:06Z</dcterms:created>
  <dcterms:modified xsi:type="dcterms:W3CDTF">2025-06-05T04:00:11Z</dcterms:modified>
</cp:coreProperties>
</file>